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9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10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1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2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3"/>
  </p:notesMasterIdLst>
  <p:sldIdLst>
    <p:sldId id="374" r:id="rId2"/>
    <p:sldId id="342" r:id="rId3"/>
    <p:sldId id="343" r:id="rId4"/>
    <p:sldId id="340" r:id="rId5"/>
    <p:sldId id="375" r:id="rId6"/>
    <p:sldId id="315" r:id="rId7"/>
    <p:sldId id="276" r:id="rId8"/>
    <p:sldId id="278" r:id="rId9"/>
    <p:sldId id="348" r:id="rId10"/>
    <p:sldId id="349" r:id="rId11"/>
    <p:sldId id="350" r:id="rId12"/>
    <p:sldId id="347" r:id="rId13"/>
    <p:sldId id="352" r:id="rId14"/>
    <p:sldId id="351" r:id="rId15"/>
    <p:sldId id="316" r:id="rId16"/>
    <p:sldId id="286" r:id="rId17"/>
    <p:sldId id="288" r:id="rId18"/>
    <p:sldId id="355" r:id="rId19"/>
    <p:sldId id="356" r:id="rId20"/>
    <p:sldId id="357" r:id="rId21"/>
    <p:sldId id="354" r:id="rId22"/>
    <p:sldId id="359" r:id="rId23"/>
    <p:sldId id="358" r:id="rId24"/>
    <p:sldId id="317" r:id="rId25"/>
    <p:sldId id="296" r:id="rId26"/>
    <p:sldId id="298" r:id="rId27"/>
    <p:sldId id="362" r:id="rId28"/>
    <p:sldId id="363" r:id="rId29"/>
    <p:sldId id="364" r:id="rId30"/>
    <p:sldId id="361" r:id="rId31"/>
    <p:sldId id="366" r:id="rId32"/>
    <p:sldId id="365" r:id="rId33"/>
    <p:sldId id="318" r:id="rId34"/>
    <p:sldId id="308" r:id="rId35"/>
    <p:sldId id="309" r:id="rId36"/>
    <p:sldId id="369" r:id="rId37"/>
    <p:sldId id="370" r:id="rId38"/>
    <p:sldId id="371" r:id="rId39"/>
    <p:sldId id="368" r:id="rId40"/>
    <p:sldId id="373" r:id="rId41"/>
    <p:sldId id="372" r:id="rId42"/>
  </p:sldIdLst>
  <p:sldSz cx="9144000" cy="6858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밝은 스타일 1 - 강조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42" autoAdjust="0"/>
    <p:restoredTop sz="94660"/>
  </p:normalViewPr>
  <p:slideViewPr>
    <p:cSldViewPr>
      <p:cViewPr varScale="1">
        <p:scale>
          <a:sx n="87" d="100"/>
          <a:sy n="87" d="100"/>
        </p:scale>
        <p:origin x="1638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notesMaster" Target="notesMasters/notesMaster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theme" Target="theme/theme1.xml"/><Relationship Id="rId20" Type="http://schemas.openxmlformats.org/officeDocument/2006/relationships/slide" Target="slides/slide19.xml"/><Relationship Id="rId41" Type="http://schemas.openxmlformats.org/officeDocument/2006/relationships/slide" Target="slides/slide40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my%20own%20documents\Olivier\3CV\Her2p_CV3_betas.csv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my%20own%20documents\Olivier\3CV\Her2pERn_CV3_betas.csv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my%20own%20documents\Olivier\160628\Her2pERn\Her2pERn_boot_res.csv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my%20own%20documents\Olivier\160628\Her2pERn\Her2pERn_boot_res.csv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my%20own%20documents\Olivier\160628\Her2p\Her2p_boot_res.csv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my%20own%20documents\Olivier\160628\Her2p\Her2p_boot_res.csv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my%20own%20documents\Olivier\3CV\Luminal_CV3_betas.csv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my%20own%20documents\Olivier\160628\Luminal\Luminal_boot_res.csv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my%20own%20documents\Olivier\160628\Luminal\Luminal_boot_res.csv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my%20own%20documents\Olivier\3CV\TN_CV3_betas.csv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my%20own%20documents\Olivier\160628\TN\TN_boot_res.csv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my%20own%20documents\Olivier\160628\TN\TN_boot_res.csv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er2p_CV3_betas!$N$7</c:f>
              <c:strCache>
                <c:ptCount val="1"/>
                <c:pt idx="0">
                  <c:v>LASSO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Her2p_CV3_betas!$M$8:$M$21</c:f>
              <c:strCache>
                <c:ptCount val="14"/>
                <c:pt idx="0">
                  <c:v>X5450</c:v>
                </c:pt>
                <c:pt idx="1">
                  <c:v>X10563</c:v>
                </c:pt>
                <c:pt idx="2">
                  <c:v>X79919</c:v>
                </c:pt>
                <c:pt idx="3">
                  <c:v>X6286</c:v>
                </c:pt>
                <c:pt idx="4">
                  <c:v>X6278</c:v>
                </c:pt>
                <c:pt idx="5">
                  <c:v>X6279</c:v>
                </c:pt>
                <c:pt idx="6">
                  <c:v>X3667</c:v>
                </c:pt>
                <c:pt idx="7">
                  <c:v>X6652</c:v>
                </c:pt>
                <c:pt idx="8">
                  <c:v>X5046</c:v>
                </c:pt>
                <c:pt idx="9">
                  <c:v>X2099</c:v>
                </c:pt>
                <c:pt idx="10">
                  <c:v>X5264</c:v>
                </c:pt>
                <c:pt idx="11">
                  <c:v>X56521</c:v>
                </c:pt>
                <c:pt idx="12">
                  <c:v>X12</c:v>
                </c:pt>
                <c:pt idx="13">
                  <c:v>X9</c:v>
                </c:pt>
              </c:strCache>
            </c:strRef>
          </c:cat>
          <c:val>
            <c:numRef>
              <c:f>Her2p_CV3_betas!$N$8:$N$21</c:f>
              <c:numCache>
                <c:formatCode>General</c:formatCode>
                <c:ptCount val="14"/>
                <c:pt idx="0">
                  <c:v>0.112381971322619</c:v>
                </c:pt>
                <c:pt idx="1">
                  <c:v>6.2948596023177497E-2</c:v>
                </c:pt>
                <c:pt idx="2">
                  <c:v>3.4403165798306899E-2</c:v>
                </c:pt>
                <c:pt idx="3">
                  <c:v>2.6991087726167401E-2</c:v>
                </c:pt>
                <c:pt idx="4">
                  <c:v>8.9443770895288703E-3</c:v>
                </c:pt>
                <c:pt idx="5">
                  <c:v>1.1370876558551399E-3</c:v>
                </c:pt>
                <c:pt idx="6">
                  <c:v>-3.24379775945287E-3</c:v>
                </c:pt>
                <c:pt idx="7">
                  <c:v>-3.42825221699747E-3</c:v>
                </c:pt>
                <c:pt idx="8">
                  <c:v>-1.9029987784792399E-2</c:v>
                </c:pt>
                <c:pt idx="9">
                  <c:v>-2.0481208461888199E-2</c:v>
                </c:pt>
                <c:pt idx="10">
                  <c:v>-2.3630597171357199E-2</c:v>
                </c:pt>
                <c:pt idx="11">
                  <c:v>-3.8509709386126703E-2</c:v>
                </c:pt>
                <c:pt idx="12">
                  <c:v>-7.0892765198212804E-2</c:v>
                </c:pt>
                <c:pt idx="13">
                  <c:v>-8.9059506567577301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2EE-48C9-9D27-F9917E00706F}"/>
            </c:ext>
          </c:extLst>
        </c:ser>
        <c:ser>
          <c:idx val="1"/>
          <c:order val="1"/>
          <c:tx>
            <c:strRef>
              <c:f>Her2p_CV3_betas!$O$7</c:f>
              <c:strCache>
                <c:ptCount val="1"/>
                <c:pt idx="0">
                  <c:v>MU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Her2p_CV3_betas!$M$8:$M$21</c:f>
              <c:strCache>
                <c:ptCount val="14"/>
                <c:pt idx="0">
                  <c:v>X5450</c:v>
                </c:pt>
                <c:pt idx="1">
                  <c:v>X10563</c:v>
                </c:pt>
                <c:pt idx="2">
                  <c:v>X79919</c:v>
                </c:pt>
                <c:pt idx="3">
                  <c:v>X6286</c:v>
                </c:pt>
                <c:pt idx="4">
                  <c:v>X6278</c:v>
                </c:pt>
                <c:pt idx="5">
                  <c:v>X6279</c:v>
                </c:pt>
                <c:pt idx="6">
                  <c:v>X3667</c:v>
                </c:pt>
                <c:pt idx="7">
                  <c:v>X6652</c:v>
                </c:pt>
                <c:pt idx="8">
                  <c:v>X5046</c:v>
                </c:pt>
                <c:pt idx="9">
                  <c:v>X2099</c:v>
                </c:pt>
                <c:pt idx="10">
                  <c:v>X5264</c:v>
                </c:pt>
                <c:pt idx="11">
                  <c:v>X56521</c:v>
                </c:pt>
                <c:pt idx="12">
                  <c:v>X12</c:v>
                </c:pt>
                <c:pt idx="13">
                  <c:v>X9</c:v>
                </c:pt>
              </c:strCache>
            </c:strRef>
          </c:cat>
          <c:val>
            <c:numRef>
              <c:f>Her2p_CV3_betas!$O$8:$O$21</c:f>
              <c:numCache>
                <c:formatCode>General</c:formatCode>
                <c:ptCount val="14"/>
                <c:pt idx="0">
                  <c:v>0.2688470182713750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-0.224779704253377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2EE-48C9-9D27-F9917E0070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385504"/>
        <c:axId val="120386064"/>
      </c:barChart>
      <c:catAx>
        <c:axId val="12038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20386064"/>
        <c:crosses val="autoZero"/>
        <c:auto val="1"/>
        <c:lblAlgn val="ctr"/>
        <c:lblOffset val="100"/>
        <c:noMultiLvlLbl val="0"/>
      </c:catAx>
      <c:valAx>
        <c:axId val="120386064"/>
        <c:scaling>
          <c:orientation val="minMax"/>
        </c:scaling>
        <c:delete val="0"/>
        <c:axPos val="l"/>
        <c:numFmt formatCode="#,##0.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20385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lb-L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b-LU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er2pERn_CV3_betas!$T$6</c:f>
              <c:strCache>
                <c:ptCount val="1"/>
                <c:pt idx="0">
                  <c:v>LASSO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Her2pERn_CV3_betas!$S$7:$S$34</c:f>
              <c:strCache>
                <c:ptCount val="28"/>
                <c:pt idx="0">
                  <c:v>X10563</c:v>
                </c:pt>
                <c:pt idx="1">
                  <c:v>X6286</c:v>
                </c:pt>
                <c:pt idx="2">
                  <c:v>X5450</c:v>
                </c:pt>
                <c:pt idx="3">
                  <c:v>X7031</c:v>
                </c:pt>
                <c:pt idx="4">
                  <c:v>X79919</c:v>
                </c:pt>
                <c:pt idx="5">
                  <c:v>X1848</c:v>
                </c:pt>
                <c:pt idx="6">
                  <c:v>X85453</c:v>
                </c:pt>
                <c:pt idx="7">
                  <c:v>X2261</c:v>
                </c:pt>
                <c:pt idx="8">
                  <c:v>X79589</c:v>
                </c:pt>
                <c:pt idx="9">
                  <c:v>X3866</c:v>
                </c:pt>
                <c:pt idx="10">
                  <c:v>X4147</c:v>
                </c:pt>
                <c:pt idx="11">
                  <c:v>X1301</c:v>
                </c:pt>
                <c:pt idx="12">
                  <c:v>X6362</c:v>
                </c:pt>
                <c:pt idx="13">
                  <c:v>X55286</c:v>
                </c:pt>
                <c:pt idx="14">
                  <c:v>X50486</c:v>
                </c:pt>
                <c:pt idx="15">
                  <c:v>X4824</c:v>
                </c:pt>
                <c:pt idx="16">
                  <c:v>X4250</c:v>
                </c:pt>
                <c:pt idx="17">
                  <c:v>X5362</c:v>
                </c:pt>
                <c:pt idx="18">
                  <c:v>X4256</c:v>
                </c:pt>
                <c:pt idx="19">
                  <c:v>X6898</c:v>
                </c:pt>
                <c:pt idx="20">
                  <c:v>X4246</c:v>
                </c:pt>
                <c:pt idx="21">
                  <c:v>X6535</c:v>
                </c:pt>
                <c:pt idx="22">
                  <c:v>X8714</c:v>
                </c:pt>
                <c:pt idx="23">
                  <c:v>X2877</c:v>
                </c:pt>
                <c:pt idx="24">
                  <c:v>X55876</c:v>
                </c:pt>
                <c:pt idx="25">
                  <c:v>X11341</c:v>
                </c:pt>
                <c:pt idx="26">
                  <c:v>X4830</c:v>
                </c:pt>
                <c:pt idx="27">
                  <c:v>X3655</c:v>
                </c:pt>
              </c:strCache>
            </c:strRef>
          </c:cat>
          <c:val>
            <c:numRef>
              <c:f>Her2pERn_CV3_betas!$T$7:$T$34</c:f>
              <c:numCache>
                <c:formatCode>General</c:formatCode>
                <c:ptCount val="28"/>
                <c:pt idx="0">
                  <c:v>0.41723936975880799</c:v>
                </c:pt>
                <c:pt idx="1">
                  <c:v>0.43372652864939099</c:v>
                </c:pt>
                <c:pt idx="2">
                  <c:v>0.29996366382413903</c:v>
                </c:pt>
                <c:pt idx="3">
                  <c:v>0.28692025083011902</c:v>
                </c:pt>
                <c:pt idx="4">
                  <c:v>0.27241469169355997</c:v>
                </c:pt>
                <c:pt idx="5">
                  <c:v>0.232517161643158</c:v>
                </c:pt>
                <c:pt idx="6">
                  <c:v>0.196331794224645</c:v>
                </c:pt>
                <c:pt idx="7">
                  <c:v>0.100315873649326</c:v>
                </c:pt>
                <c:pt idx="8">
                  <c:v>8.3708044855795805E-2</c:v>
                </c:pt>
                <c:pt idx="9">
                  <c:v>8.1707620345922993E-2</c:v>
                </c:pt>
                <c:pt idx="10">
                  <c:v>8.0444465348632005E-2</c:v>
                </c:pt>
                <c:pt idx="11">
                  <c:v>7.0244784328315005E-2</c:v>
                </c:pt>
                <c:pt idx="12">
                  <c:v>3.87938326733826E-2</c:v>
                </c:pt>
                <c:pt idx="13">
                  <c:v>2.7240533024855299E-2</c:v>
                </c:pt>
                <c:pt idx="14">
                  <c:v>8.7351915388404703E-3</c:v>
                </c:pt>
                <c:pt idx="15">
                  <c:v>-1.3708518756282701E-2</c:v>
                </c:pt>
                <c:pt idx="16">
                  <c:v>-2.7354673431692001E-2</c:v>
                </c:pt>
                <c:pt idx="17">
                  <c:v>-6.0231537137267997E-2</c:v>
                </c:pt>
                <c:pt idx="18">
                  <c:v>-9.0257515402406993E-2</c:v>
                </c:pt>
                <c:pt idx="19">
                  <c:v>-9.6657611781086797E-2</c:v>
                </c:pt>
                <c:pt idx="20">
                  <c:v>-0.112308155956007</c:v>
                </c:pt>
                <c:pt idx="21">
                  <c:v>-0.12186222170788</c:v>
                </c:pt>
                <c:pt idx="22">
                  <c:v>-0.135252577269147</c:v>
                </c:pt>
                <c:pt idx="23">
                  <c:v>-0.250350294100667</c:v>
                </c:pt>
                <c:pt idx="24">
                  <c:v>-0.275611990151095</c:v>
                </c:pt>
                <c:pt idx="25">
                  <c:v>-0.40137241050526101</c:v>
                </c:pt>
                <c:pt idx="26">
                  <c:v>-0.58455441953826803</c:v>
                </c:pt>
                <c:pt idx="27">
                  <c:v>-0.644542490706320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040-4066-A417-91F81A872F68}"/>
            </c:ext>
          </c:extLst>
        </c:ser>
        <c:ser>
          <c:idx val="1"/>
          <c:order val="1"/>
          <c:tx>
            <c:strRef>
              <c:f>Her2pERn_CV3_betas!$U$6</c:f>
              <c:strCache>
                <c:ptCount val="1"/>
                <c:pt idx="0">
                  <c:v>MU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Her2pERn_CV3_betas!$S$7:$S$34</c:f>
              <c:strCache>
                <c:ptCount val="28"/>
                <c:pt idx="0">
                  <c:v>X10563</c:v>
                </c:pt>
                <c:pt idx="1">
                  <c:v>X6286</c:v>
                </c:pt>
                <c:pt idx="2">
                  <c:v>X5450</c:v>
                </c:pt>
                <c:pt idx="3">
                  <c:v>X7031</c:v>
                </c:pt>
                <c:pt idx="4">
                  <c:v>X79919</c:v>
                </c:pt>
                <c:pt idx="5">
                  <c:v>X1848</c:v>
                </c:pt>
                <c:pt idx="6">
                  <c:v>X85453</c:v>
                </c:pt>
                <c:pt idx="7">
                  <c:v>X2261</c:v>
                </c:pt>
                <c:pt idx="8">
                  <c:v>X79589</c:v>
                </c:pt>
                <c:pt idx="9">
                  <c:v>X3866</c:v>
                </c:pt>
                <c:pt idx="10">
                  <c:v>X4147</c:v>
                </c:pt>
                <c:pt idx="11">
                  <c:v>X1301</c:v>
                </c:pt>
                <c:pt idx="12">
                  <c:v>X6362</c:v>
                </c:pt>
                <c:pt idx="13">
                  <c:v>X55286</c:v>
                </c:pt>
                <c:pt idx="14">
                  <c:v>X50486</c:v>
                </c:pt>
                <c:pt idx="15">
                  <c:v>X4824</c:v>
                </c:pt>
                <c:pt idx="16">
                  <c:v>X4250</c:v>
                </c:pt>
                <c:pt idx="17">
                  <c:v>X5362</c:v>
                </c:pt>
                <c:pt idx="18">
                  <c:v>X4256</c:v>
                </c:pt>
                <c:pt idx="19">
                  <c:v>X6898</c:v>
                </c:pt>
                <c:pt idx="20">
                  <c:v>X4246</c:v>
                </c:pt>
                <c:pt idx="21">
                  <c:v>X6535</c:v>
                </c:pt>
                <c:pt idx="22">
                  <c:v>X8714</c:v>
                </c:pt>
                <c:pt idx="23">
                  <c:v>X2877</c:v>
                </c:pt>
                <c:pt idx="24">
                  <c:v>X55876</c:v>
                </c:pt>
                <c:pt idx="25">
                  <c:v>X11341</c:v>
                </c:pt>
                <c:pt idx="26">
                  <c:v>X4830</c:v>
                </c:pt>
                <c:pt idx="27">
                  <c:v>X3655</c:v>
                </c:pt>
              </c:strCache>
            </c:strRef>
          </c:cat>
          <c:val>
            <c:numRef>
              <c:f>Her2pERn_CV3_betas!$U$7:$U$34</c:f>
              <c:numCache>
                <c:formatCode>General</c:formatCode>
                <c:ptCount val="28"/>
                <c:pt idx="0">
                  <c:v>0.306291271960554</c:v>
                </c:pt>
                <c:pt idx="1">
                  <c:v>0.19961161205803099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-0.733263712969014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040-4066-A417-91F81A872F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1414928"/>
        <c:axId val="191415488"/>
      </c:barChart>
      <c:catAx>
        <c:axId val="191414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1415488"/>
        <c:crosses val="autoZero"/>
        <c:auto val="1"/>
        <c:lblAlgn val="ctr"/>
        <c:lblOffset val="100"/>
        <c:noMultiLvlLbl val="0"/>
      </c:catAx>
      <c:valAx>
        <c:axId val="191415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1414928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lb-L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b-LU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lb-LU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LASSO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1!$A$2:$A$51</c:f>
              <c:strCache>
                <c:ptCount val="50"/>
                <c:pt idx="0">
                  <c:v>X10563</c:v>
                </c:pt>
                <c:pt idx="1">
                  <c:v>X7031</c:v>
                </c:pt>
                <c:pt idx="2">
                  <c:v>X6286</c:v>
                </c:pt>
                <c:pt idx="3">
                  <c:v>X6362</c:v>
                </c:pt>
                <c:pt idx="4">
                  <c:v>X55876</c:v>
                </c:pt>
                <c:pt idx="5">
                  <c:v>X4830</c:v>
                </c:pt>
                <c:pt idx="6">
                  <c:v>X2877</c:v>
                </c:pt>
                <c:pt idx="7">
                  <c:v>X6898</c:v>
                </c:pt>
                <c:pt idx="8">
                  <c:v>X4256</c:v>
                </c:pt>
                <c:pt idx="9">
                  <c:v>X79919</c:v>
                </c:pt>
                <c:pt idx="10">
                  <c:v>X85453</c:v>
                </c:pt>
                <c:pt idx="11">
                  <c:v>X1448</c:v>
                </c:pt>
                <c:pt idx="12">
                  <c:v>X6278</c:v>
                </c:pt>
                <c:pt idx="13">
                  <c:v>X1301</c:v>
                </c:pt>
                <c:pt idx="14">
                  <c:v>X3655</c:v>
                </c:pt>
                <c:pt idx="15">
                  <c:v>X10321</c:v>
                </c:pt>
                <c:pt idx="16">
                  <c:v>X12</c:v>
                </c:pt>
                <c:pt idx="17">
                  <c:v>X4250</c:v>
                </c:pt>
                <c:pt idx="18">
                  <c:v>X6279</c:v>
                </c:pt>
                <c:pt idx="19">
                  <c:v>X23089</c:v>
                </c:pt>
                <c:pt idx="20">
                  <c:v>X5450</c:v>
                </c:pt>
                <c:pt idx="21">
                  <c:v>X80736</c:v>
                </c:pt>
                <c:pt idx="22">
                  <c:v>X1475</c:v>
                </c:pt>
                <c:pt idx="23">
                  <c:v>X9862</c:v>
                </c:pt>
                <c:pt idx="24">
                  <c:v>X1672</c:v>
                </c:pt>
                <c:pt idx="25">
                  <c:v>X347</c:v>
                </c:pt>
                <c:pt idx="26">
                  <c:v>X4824</c:v>
                </c:pt>
                <c:pt idx="27">
                  <c:v>X8842</c:v>
                </c:pt>
                <c:pt idx="28">
                  <c:v>X1978</c:v>
                </c:pt>
                <c:pt idx="29">
                  <c:v>X4147</c:v>
                </c:pt>
                <c:pt idx="30">
                  <c:v>X59272</c:v>
                </c:pt>
                <c:pt idx="31">
                  <c:v>X2261</c:v>
                </c:pt>
                <c:pt idx="32">
                  <c:v>X3866</c:v>
                </c:pt>
                <c:pt idx="33">
                  <c:v>X4477</c:v>
                </c:pt>
                <c:pt idx="34">
                  <c:v>X4680</c:v>
                </c:pt>
                <c:pt idx="35">
                  <c:v>X253190</c:v>
                </c:pt>
                <c:pt idx="36">
                  <c:v>X23532</c:v>
                </c:pt>
                <c:pt idx="37">
                  <c:v>X4246</c:v>
                </c:pt>
                <c:pt idx="38">
                  <c:v>X5304</c:v>
                </c:pt>
                <c:pt idx="39">
                  <c:v>X8714</c:v>
                </c:pt>
                <c:pt idx="40">
                  <c:v>X360</c:v>
                </c:pt>
                <c:pt idx="41">
                  <c:v>X55286</c:v>
                </c:pt>
                <c:pt idx="42">
                  <c:v>X3929</c:v>
                </c:pt>
                <c:pt idx="43">
                  <c:v>X11341</c:v>
                </c:pt>
                <c:pt idx="44">
                  <c:v>X2539</c:v>
                </c:pt>
                <c:pt idx="45">
                  <c:v>X3212</c:v>
                </c:pt>
                <c:pt idx="46">
                  <c:v>X81569</c:v>
                </c:pt>
                <c:pt idx="47">
                  <c:v>X10202</c:v>
                </c:pt>
                <c:pt idx="48">
                  <c:v>X1848</c:v>
                </c:pt>
                <c:pt idx="49">
                  <c:v>X2019</c:v>
                </c:pt>
              </c:strCache>
            </c:strRef>
          </c:cat>
          <c:val>
            <c:numRef>
              <c:f>Sheet1!$B$2:$B$51</c:f>
              <c:numCache>
                <c:formatCode>General</c:formatCode>
                <c:ptCount val="50"/>
                <c:pt idx="0">
                  <c:v>78</c:v>
                </c:pt>
                <c:pt idx="1">
                  <c:v>60</c:v>
                </c:pt>
                <c:pt idx="2">
                  <c:v>56</c:v>
                </c:pt>
                <c:pt idx="3">
                  <c:v>48</c:v>
                </c:pt>
                <c:pt idx="4">
                  <c:v>44</c:v>
                </c:pt>
                <c:pt idx="5">
                  <c:v>41</c:v>
                </c:pt>
                <c:pt idx="6">
                  <c:v>39</c:v>
                </c:pt>
                <c:pt idx="7">
                  <c:v>37</c:v>
                </c:pt>
                <c:pt idx="8">
                  <c:v>35</c:v>
                </c:pt>
                <c:pt idx="9">
                  <c:v>33</c:v>
                </c:pt>
                <c:pt idx="10">
                  <c:v>32</c:v>
                </c:pt>
                <c:pt idx="11">
                  <c:v>30</c:v>
                </c:pt>
                <c:pt idx="12">
                  <c:v>30</c:v>
                </c:pt>
                <c:pt idx="13">
                  <c:v>29</c:v>
                </c:pt>
                <c:pt idx="14">
                  <c:v>29</c:v>
                </c:pt>
                <c:pt idx="15">
                  <c:v>28</c:v>
                </c:pt>
                <c:pt idx="16">
                  <c:v>28</c:v>
                </c:pt>
                <c:pt idx="17">
                  <c:v>27</c:v>
                </c:pt>
                <c:pt idx="18">
                  <c:v>26</c:v>
                </c:pt>
                <c:pt idx="19">
                  <c:v>25</c:v>
                </c:pt>
                <c:pt idx="20">
                  <c:v>25</c:v>
                </c:pt>
                <c:pt idx="21">
                  <c:v>25</c:v>
                </c:pt>
                <c:pt idx="22">
                  <c:v>24</c:v>
                </c:pt>
                <c:pt idx="23">
                  <c:v>24</c:v>
                </c:pt>
                <c:pt idx="24">
                  <c:v>22</c:v>
                </c:pt>
                <c:pt idx="25">
                  <c:v>22</c:v>
                </c:pt>
                <c:pt idx="26">
                  <c:v>22</c:v>
                </c:pt>
                <c:pt idx="27">
                  <c:v>22</c:v>
                </c:pt>
                <c:pt idx="28">
                  <c:v>21</c:v>
                </c:pt>
                <c:pt idx="29">
                  <c:v>21</c:v>
                </c:pt>
                <c:pt idx="30">
                  <c:v>21</c:v>
                </c:pt>
                <c:pt idx="31">
                  <c:v>20</c:v>
                </c:pt>
                <c:pt idx="32">
                  <c:v>20</c:v>
                </c:pt>
                <c:pt idx="33">
                  <c:v>20</c:v>
                </c:pt>
                <c:pt idx="34">
                  <c:v>19</c:v>
                </c:pt>
                <c:pt idx="35">
                  <c:v>18</c:v>
                </c:pt>
                <c:pt idx="36">
                  <c:v>17</c:v>
                </c:pt>
                <c:pt idx="37">
                  <c:v>17</c:v>
                </c:pt>
                <c:pt idx="38">
                  <c:v>17</c:v>
                </c:pt>
                <c:pt idx="39">
                  <c:v>17</c:v>
                </c:pt>
                <c:pt idx="40">
                  <c:v>16</c:v>
                </c:pt>
                <c:pt idx="41">
                  <c:v>16</c:v>
                </c:pt>
                <c:pt idx="42">
                  <c:v>15</c:v>
                </c:pt>
                <c:pt idx="43">
                  <c:v>14</c:v>
                </c:pt>
                <c:pt idx="44">
                  <c:v>14</c:v>
                </c:pt>
                <c:pt idx="45">
                  <c:v>14</c:v>
                </c:pt>
                <c:pt idx="46">
                  <c:v>14</c:v>
                </c:pt>
                <c:pt idx="47">
                  <c:v>13</c:v>
                </c:pt>
                <c:pt idx="48">
                  <c:v>13</c:v>
                </c:pt>
                <c:pt idx="49">
                  <c:v>1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229-4BE7-BB55-3384F389E8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1417728"/>
        <c:axId val="191418288"/>
      </c:lineChart>
      <c:catAx>
        <c:axId val="191417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1418288"/>
        <c:crosses val="autoZero"/>
        <c:auto val="1"/>
        <c:lblAlgn val="ctr"/>
        <c:lblOffset val="100"/>
        <c:noMultiLvlLbl val="0"/>
      </c:catAx>
      <c:valAx>
        <c:axId val="191418288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1417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b-LU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lb-LU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C$1</c:f>
              <c:strCache>
                <c:ptCount val="1"/>
                <c:pt idx="0">
                  <c:v>MUB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2!$A$2:$A$51</c:f>
              <c:strCache>
                <c:ptCount val="50"/>
                <c:pt idx="0">
                  <c:v>X10563</c:v>
                </c:pt>
                <c:pt idx="1">
                  <c:v>X7031</c:v>
                </c:pt>
                <c:pt idx="2">
                  <c:v>X6286</c:v>
                </c:pt>
                <c:pt idx="3">
                  <c:v>X6362</c:v>
                </c:pt>
                <c:pt idx="4">
                  <c:v>X4830</c:v>
                </c:pt>
                <c:pt idx="5">
                  <c:v>X6898</c:v>
                </c:pt>
                <c:pt idx="6">
                  <c:v>X2877</c:v>
                </c:pt>
                <c:pt idx="7">
                  <c:v>X79919</c:v>
                </c:pt>
                <c:pt idx="8">
                  <c:v>X3655</c:v>
                </c:pt>
                <c:pt idx="9">
                  <c:v>X55876</c:v>
                </c:pt>
                <c:pt idx="10">
                  <c:v>X6278</c:v>
                </c:pt>
                <c:pt idx="11">
                  <c:v>X1448</c:v>
                </c:pt>
                <c:pt idx="12">
                  <c:v>X4256</c:v>
                </c:pt>
                <c:pt idx="13">
                  <c:v>X10321</c:v>
                </c:pt>
                <c:pt idx="14">
                  <c:v>X6279</c:v>
                </c:pt>
                <c:pt idx="15">
                  <c:v>X4477</c:v>
                </c:pt>
                <c:pt idx="16">
                  <c:v>X59272</c:v>
                </c:pt>
                <c:pt idx="17">
                  <c:v>X253190</c:v>
                </c:pt>
                <c:pt idx="18">
                  <c:v>X5450</c:v>
                </c:pt>
                <c:pt idx="19">
                  <c:v>X1672</c:v>
                </c:pt>
                <c:pt idx="20">
                  <c:v>X4250</c:v>
                </c:pt>
                <c:pt idx="21">
                  <c:v>X80736</c:v>
                </c:pt>
                <c:pt idx="22">
                  <c:v>X12</c:v>
                </c:pt>
                <c:pt idx="23">
                  <c:v>X23089</c:v>
                </c:pt>
                <c:pt idx="24">
                  <c:v>X347</c:v>
                </c:pt>
                <c:pt idx="25">
                  <c:v>X3866</c:v>
                </c:pt>
                <c:pt idx="26">
                  <c:v>X4147</c:v>
                </c:pt>
                <c:pt idx="27">
                  <c:v>X9862</c:v>
                </c:pt>
                <c:pt idx="28">
                  <c:v>X1978</c:v>
                </c:pt>
                <c:pt idx="29">
                  <c:v>X6696</c:v>
                </c:pt>
                <c:pt idx="30">
                  <c:v>X85453</c:v>
                </c:pt>
                <c:pt idx="31">
                  <c:v>X3212</c:v>
                </c:pt>
                <c:pt idx="32">
                  <c:v>X3929</c:v>
                </c:pt>
                <c:pt idx="33">
                  <c:v>X4246</c:v>
                </c:pt>
                <c:pt idx="34">
                  <c:v>X8714</c:v>
                </c:pt>
                <c:pt idx="35">
                  <c:v>X1301</c:v>
                </c:pt>
                <c:pt idx="36">
                  <c:v>X2261</c:v>
                </c:pt>
                <c:pt idx="37">
                  <c:v>X23532</c:v>
                </c:pt>
                <c:pt idx="38">
                  <c:v>X4824</c:v>
                </c:pt>
                <c:pt idx="39">
                  <c:v>X11341</c:v>
                </c:pt>
                <c:pt idx="40">
                  <c:v>X1356</c:v>
                </c:pt>
                <c:pt idx="41">
                  <c:v>X2539</c:v>
                </c:pt>
                <c:pt idx="42">
                  <c:v>X50486</c:v>
                </c:pt>
                <c:pt idx="43">
                  <c:v>X5304</c:v>
                </c:pt>
                <c:pt idx="44">
                  <c:v>X55286</c:v>
                </c:pt>
                <c:pt idx="45">
                  <c:v>X5788</c:v>
                </c:pt>
                <c:pt idx="46">
                  <c:v>X81569</c:v>
                </c:pt>
                <c:pt idx="47">
                  <c:v>X8842</c:v>
                </c:pt>
                <c:pt idx="48">
                  <c:v>X10202</c:v>
                </c:pt>
                <c:pt idx="49">
                  <c:v>X1475</c:v>
                </c:pt>
              </c:strCache>
            </c:strRef>
          </c:cat>
          <c:val>
            <c:numRef>
              <c:f>Sheet2!$C$2:$C$51</c:f>
              <c:numCache>
                <c:formatCode>General</c:formatCode>
                <c:ptCount val="50"/>
                <c:pt idx="0">
                  <c:v>68</c:v>
                </c:pt>
                <c:pt idx="1">
                  <c:v>44</c:v>
                </c:pt>
                <c:pt idx="2">
                  <c:v>37</c:v>
                </c:pt>
                <c:pt idx="3">
                  <c:v>32</c:v>
                </c:pt>
                <c:pt idx="4">
                  <c:v>25</c:v>
                </c:pt>
                <c:pt idx="5">
                  <c:v>25</c:v>
                </c:pt>
                <c:pt idx="6">
                  <c:v>24</c:v>
                </c:pt>
                <c:pt idx="7">
                  <c:v>22</c:v>
                </c:pt>
                <c:pt idx="8">
                  <c:v>19</c:v>
                </c:pt>
                <c:pt idx="9">
                  <c:v>19</c:v>
                </c:pt>
                <c:pt idx="10">
                  <c:v>19</c:v>
                </c:pt>
                <c:pt idx="11">
                  <c:v>18</c:v>
                </c:pt>
                <c:pt idx="12">
                  <c:v>18</c:v>
                </c:pt>
                <c:pt idx="13">
                  <c:v>16</c:v>
                </c:pt>
                <c:pt idx="14">
                  <c:v>16</c:v>
                </c:pt>
                <c:pt idx="15">
                  <c:v>15</c:v>
                </c:pt>
                <c:pt idx="16">
                  <c:v>15</c:v>
                </c:pt>
                <c:pt idx="17">
                  <c:v>14</c:v>
                </c:pt>
                <c:pt idx="18">
                  <c:v>14</c:v>
                </c:pt>
                <c:pt idx="19">
                  <c:v>13</c:v>
                </c:pt>
                <c:pt idx="20">
                  <c:v>13</c:v>
                </c:pt>
                <c:pt idx="21">
                  <c:v>13</c:v>
                </c:pt>
                <c:pt idx="22">
                  <c:v>12</c:v>
                </c:pt>
                <c:pt idx="23">
                  <c:v>12</c:v>
                </c:pt>
                <c:pt idx="24">
                  <c:v>12</c:v>
                </c:pt>
                <c:pt idx="25">
                  <c:v>12</c:v>
                </c:pt>
                <c:pt idx="26">
                  <c:v>12</c:v>
                </c:pt>
                <c:pt idx="27">
                  <c:v>12</c:v>
                </c:pt>
                <c:pt idx="28">
                  <c:v>11</c:v>
                </c:pt>
                <c:pt idx="29">
                  <c:v>11</c:v>
                </c:pt>
                <c:pt idx="30">
                  <c:v>11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7</c:v>
                </c:pt>
                <c:pt idx="36">
                  <c:v>7</c:v>
                </c:pt>
                <c:pt idx="37">
                  <c:v>7</c:v>
                </c:pt>
                <c:pt idx="38">
                  <c:v>7</c:v>
                </c:pt>
                <c:pt idx="39">
                  <c:v>6</c:v>
                </c:pt>
                <c:pt idx="40">
                  <c:v>6</c:v>
                </c:pt>
                <c:pt idx="41">
                  <c:v>6</c:v>
                </c:pt>
                <c:pt idx="42">
                  <c:v>6</c:v>
                </c:pt>
                <c:pt idx="43">
                  <c:v>6</c:v>
                </c:pt>
                <c:pt idx="44">
                  <c:v>6</c:v>
                </c:pt>
                <c:pt idx="45">
                  <c:v>6</c:v>
                </c:pt>
                <c:pt idx="46">
                  <c:v>6</c:v>
                </c:pt>
                <c:pt idx="47">
                  <c:v>6</c:v>
                </c:pt>
                <c:pt idx="48">
                  <c:v>5</c:v>
                </c:pt>
                <c:pt idx="49">
                  <c:v>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3E4-478C-9828-ACF4B1E527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1420528"/>
        <c:axId val="191421088"/>
      </c:lineChart>
      <c:catAx>
        <c:axId val="1914205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1421088"/>
        <c:crosses val="autoZero"/>
        <c:auto val="1"/>
        <c:lblAlgn val="ctr"/>
        <c:lblOffset val="100"/>
        <c:noMultiLvlLbl val="0"/>
      </c:catAx>
      <c:valAx>
        <c:axId val="191421088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1420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b-LU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sz="1400" b="0"/>
          </a:pPr>
          <a:endParaRPr lang="lb-LU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LASSO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1!$A$2:$A$51</c:f>
              <c:strCache>
                <c:ptCount val="50"/>
                <c:pt idx="0">
                  <c:v>X6286</c:v>
                </c:pt>
                <c:pt idx="1">
                  <c:v>X5450</c:v>
                </c:pt>
                <c:pt idx="2">
                  <c:v>X79919</c:v>
                </c:pt>
                <c:pt idx="3">
                  <c:v>X80736</c:v>
                </c:pt>
                <c:pt idx="4">
                  <c:v>X12</c:v>
                </c:pt>
                <c:pt idx="5">
                  <c:v>X347</c:v>
                </c:pt>
                <c:pt idx="6">
                  <c:v>X5168</c:v>
                </c:pt>
                <c:pt idx="7">
                  <c:v>X5304</c:v>
                </c:pt>
                <c:pt idx="8">
                  <c:v>X8842</c:v>
                </c:pt>
                <c:pt idx="9">
                  <c:v>X10321</c:v>
                </c:pt>
                <c:pt idx="10">
                  <c:v>X10563</c:v>
                </c:pt>
                <c:pt idx="11">
                  <c:v>X339479</c:v>
                </c:pt>
                <c:pt idx="12">
                  <c:v>X4320</c:v>
                </c:pt>
                <c:pt idx="13">
                  <c:v>X6898</c:v>
                </c:pt>
                <c:pt idx="14">
                  <c:v>X2244</c:v>
                </c:pt>
                <c:pt idx="15">
                  <c:v>X1301</c:v>
                </c:pt>
                <c:pt idx="16">
                  <c:v>X4246</c:v>
                </c:pt>
                <c:pt idx="17">
                  <c:v>X4969</c:v>
                </c:pt>
                <c:pt idx="18">
                  <c:v>X5264</c:v>
                </c:pt>
                <c:pt idx="19">
                  <c:v>X56521</c:v>
                </c:pt>
                <c:pt idx="20">
                  <c:v>X6362</c:v>
                </c:pt>
                <c:pt idx="21">
                  <c:v>X7021</c:v>
                </c:pt>
                <c:pt idx="22">
                  <c:v>X3866</c:v>
                </c:pt>
                <c:pt idx="23">
                  <c:v>X1081</c:v>
                </c:pt>
                <c:pt idx="24">
                  <c:v>X51442</c:v>
                </c:pt>
                <c:pt idx="25">
                  <c:v>X4283</c:v>
                </c:pt>
                <c:pt idx="26">
                  <c:v>X4477</c:v>
                </c:pt>
                <c:pt idx="27">
                  <c:v>X6278</c:v>
                </c:pt>
                <c:pt idx="28">
                  <c:v>X10562</c:v>
                </c:pt>
                <c:pt idx="29">
                  <c:v>X1728</c:v>
                </c:pt>
                <c:pt idx="30">
                  <c:v>X2877</c:v>
                </c:pt>
                <c:pt idx="31">
                  <c:v>X3929</c:v>
                </c:pt>
                <c:pt idx="32">
                  <c:v>X10040</c:v>
                </c:pt>
                <c:pt idx="33">
                  <c:v>X10103</c:v>
                </c:pt>
                <c:pt idx="34">
                  <c:v>X4256</c:v>
                </c:pt>
                <c:pt idx="35">
                  <c:v>X2001</c:v>
                </c:pt>
                <c:pt idx="36">
                  <c:v>X4312</c:v>
                </c:pt>
                <c:pt idx="37">
                  <c:v>X8476</c:v>
                </c:pt>
                <c:pt idx="38">
                  <c:v>X8644</c:v>
                </c:pt>
                <c:pt idx="39">
                  <c:v>X3212</c:v>
                </c:pt>
                <c:pt idx="40">
                  <c:v>X6273</c:v>
                </c:pt>
                <c:pt idx="41">
                  <c:v>X84525</c:v>
                </c:pt>
                <c:pt idx="42">
                  <c:v>X1978</c:v>
                </c:pt>
                <c:pt idx="43">
                  <c:v>X222</c:v>
                </c:pt>
                <c:pt idx="44">
                  <c:v>X23336</c:v>
                </c:pt>
                <c:pt idx="45">
                  <c:v>X1047</c:v>
                </c:pt>
                <c:pt idx="46">
                  <c:v>X3434</c:v>
                </c:pt>
                <c:pt idx="47">
                  <c:v>X7031</c:v>
                </c:pt>
                <c:pt idx="48">
                  <c:v>X1360</c:v>
                </c:pt>
                <c:pt idx="49">
                  <c:v>X4680</c:v>
                </c:pt>
              </c:strCache>
            </c:strRef>
          </c:cat>
          <c:val>
            <c:numRef>
              <c:f>Sheet1!$B$2:$B$51</c:f>
              <c:numCache>
                <c:formatCode>General</c:formatCode>
                <c:ptCount val="50"/>
                <c:pt idx="0">
                  <c:v>80</c:v>
                </c:pt>
                <c:pt idx="1">
                  <c:v>61</c:v>
                </c:pt>
                <c:pt idx="2">
                  <c:v>61</c:v>
                </c:pt>
                <c:pt idx="3">
                  <c:v>58</c:v>
                </c:pt>
                <c:pt idx="4">
                  <c:v>57</c:v>
                </c:pt>
                <c:pt idx="5">
                  <c:v>57</c:v>
                </c:pt>
                <c:pt idx="6">
                  <c:v>47</c:v>
                </c:pt>
                <c:pt idx="7">
                  <c:v>46</c:v>
                </c:pt>
                <c:pt idx="8">
                  <c:v>45</c:v>
                </c:pt>
                <c:pt idx="9">
                  <c:v>42</c:v>
                </c:pt>
                <c:pt idx="10">
                  <c:v>42</c:v>
                </c:pt>
                <c:pt idx="11">
                  <c:v>38</c:v>
                </c:pt>
                <c:pt idx="12">
                  <c:v>38</c:v>
                </c:pt>
                <c:pt idx="13">
                  <c:v>38</c:v>
                </c:pt>
                <c:pt idx="14">
                  <c:v>37</c:v>
                </c:pt>
                <c:pt idx="15">
                  <c:v>36</c:v>
                </c:pt>
                <c:pt idx="16">
                  <c:v>36</c:v>
                </c:pt>
                <c:pt idx="17">
                  <c:v>36</c:v>
                </c:pt>
                <c:pt idx="18">
                  <c:v>35</c:v>
                </c:pt>
                <c:pt idx="19">
                  <c:v>35</c:v>
                </c:pt>
                <c:pt idx="20">
                  <c:v>33</c:v>
                </c:pt>
                <c:pt idx="21">
                  <c:v>33</c:v>
                </c:pt>
                <c:pt idx="22">
                  <c:v>32</c:v>
                </c:pt>
                <c:pt idx="23">
                  <c:v>31</c:v>
                </c:pt>
                <c:pt idx="24">
                  <c:v>31</c:v>
                </c:pt>
                <c:pt idx="25">
                  <c:v>30</c:v>
                </c:pt>
                <c:pt idx="26">
                  <c:v>29</c:v>
                </c:pt>
                <c:pt idx="27">
                  <c:v>29</c:v>
                </c:pt>
                <c:pt idx="28">
                  <c:v>28</c:v>
                </c:pt>
                <c:pt idx="29">
                  <c:v>28</c:v>
                </c:pt>
                <c:pt idx="30">
                  <c:v>28</c:v>
                </c:pt>
                <c:pt idx="31">
                  <c:v>28</c:v>
                </c:pt>
                <c:pt idx="32">
                  <c:v>27</c:v>
                </c:pt>
                <c:pt idx="33">
                  <c:v>27</c:v>
                </c:pt>
                <c:pt idx="34">
                  <c:v>26</c:v>
                </c:pt>
                <c:pt idx="35">
                  <c:v>25</c:v>
                </c:pt>
                <c:pt idx="36">
                  <c:v>24</c:v>
                </c:pt>
                <c:pt idx="37">
                  <c:v>24</c:v>
                </c:pt>
                <c:pt idx="38">
                  <c:v>24</c:v>
                </c:pt>
                <c:pt idx="39">
                  <c:v>23</c:v>
                </c:pt>
                <c:pt idx="40">
                  <c:v>23</c:v>
                </c:pt>
                <c:pt idx="41">
                  <c:v>23</c:v>
                </c:pt>
                <c:pt idx="42">
                  <c:v>22</c:v>
                </c:pt>
                <c:pt idx="43">
                  <c:v>22</c:v>
                </c:pt>
                <c:pt idx="44">
                  <c:v>22</c:v>
                </c:pt>
                <c:pt idx="45">
                  <c:v>21</c:v>
                </c:pt>
                <c:pt idx="46">
                  <c:v>21</c:v>
                </c:pt>
                <c:pt idx="47">
                  <c:v>21</c:v>
                </c:pt>
                <c:pt idx="48">
                  <c:v>20</c:v>
                </c:pt>
                <c:pt idx="49">
                  <c:v>2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B4E-47EB-B823-5F903B2173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9434224"/>
        <c:axId val="189434784"/>
      </c:lineChart>
      <c:catAx>
        <c:axId val="189434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lb-LU"/>
          </a:p>
        </c:txPr>
        <c:crossAx val="189434784"/>
        <c:crosses val="autoZero"/>
        <c:auto val="1"/>
        <c:lblAlgn val="ctr"/>
        <c:lblOffset val="100"/>
        <c:noMultiLvlLbl val="0"/>
      </c:catAx>
      <c:valAx>
        <c:axId val="189434784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lb-LU"/>
          </a:p>
        </c:txPr>
        <c:crossAx val="189434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/>
      </a:pPr>
      <a:endParaRPr lang="lb-LU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lb-LU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C$1</c:f>
              <c:strCache>
                <c:ptCount val="1"/>
                <c:pt idx="0">
                  <c:v>MUB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2!$A$2:$A$51</c:f>
              <c:strCache>
                <c:ptCount val="50"/>
                <c:pt idx="0">
                  <c:v>X6286</c:v>
                </c:pt>
                <c:pt idx="1">
                  <c:v>X5450</c:v>
                </c:pt>
                <c:pt idx="2">
                  <c:v>X12</c:v>
                </c:pt>
                <c:pt idx="3">
                  <c:v>X79919</c:v>
                </c:pt>
                <c:pt idx="4">
                  <c:v>X347</c:v>
                </c:pt>
                <c:pt idx="5">
                  <c:v>X10563</c:v>
                </c:pt>
                <c:pt idx="6">
                  <c:v>X80736</c:v>
                </c:pt>
                <c:pt idx="7">
                  <c:v>X5264</c:v>
                </c:pt>
                <c:pt idx="8">
                  <c:v>X8842</c:v>
                </c:pt>
                <c:pt idx="9">
                  <c:v>X56521</c:v>
                </c:pt>
                <c:pt idx="10">
                  <c:v>X6362</c:v>
                </c:pt>
                <c:pt idx="11">
                  <c:v>X10321</c:v>
                </c:pt>
                <c:pt idx="12">
                  <c:v>X7021</c:v>
                </c:pt>
                <c:pt idx="13">
                  <c:v>X10103</c:v>
                </c:pt>
                <c:pt idx="14">
                  <c:v>X2244</c:v>
                </c:pt>
                <c:pt idx="15">
                  <c:v>X4283</c:v>
                </c:pt>
                <c:pt idx="16">
                  <c:v>X5304</c:v>
                </c:pt>
                <c:pt idx="17">
                  <c:v>X6898</c:v>
                </c:pt>
                <c:pt idx="18">
                  <c:v>X1728</c:v>
                </c:pt>
                <c:pt idx="19">
                  <c:v>X339479</c:v>
                </c:pt>
                <c:pt idx="20">
                  <c:v>X51442</c:v>
                </c:pt>
                <c:pt idx="21">
                  <c:v>X6278</c:v>
                </c:pt>
                <c:pt idx="22">
                  <c:v>X4320</c:v>
                </c:pt>
                <c:pt idx="23">
                  <c:v>X5168</c:v>
                </c:pt>
                <c:pt idx="24">
                  <c:v>X1301</c:v>
                </c:pt>
                <c:pt idx="25">
                  <c:v>X9498</c:v>
                </c:pt>
                <c:pt idx="26">
                  <c:v>X1978</c:v>
                </c:pt>
                <c:pt idx="27">
                  <c:v>X2877</c:v>
                </c:pt>
                <c:pt idx="28">
                  <c:v>X3866</c:v>
                </c:pt>
                <c:pt idx="29">
                  <c:v>X4969</c:v>
                </c:pt>
                <c:pt idx="30">
                  <c:v>X79844</c:v>
                </c:pt>
                <c:pt idx="31">
                  <c:v>X8476</c:v>
                </c:pt>
                <c:pt idx="32">
                  <c:v>X4246</c:v>
                </c:pt>
                <c:pt idx="33">
                  <c:v>X4312</c:v>
                </c:pt>
                <c:pt idx="34">
                  <c:v>X4477</c:v>
                </c:pt>
                <c:pt idx="35">
                  <c:v>X10562</c:v>
                </c:pt>
                <c:pt idx="36">
                  <c:v>X253190</c:v>
                </c:pt>
                <c:pt idx="37">
                  <c:v>X3929</c:v>
                </c:pt>
                <c:pt idx="38">
                  <c:v>X6273</c:v>
                </c:pt>
                <c:pt idx="39">
                  <c:v>X9</c:v>
                </c:pt>
                <c:pt idx="40">
                  <c:v>X10040</c:v>
                </c:pt>
                <c:pt idx="41">
                  <c:v>X4256</c:v>
                </c:pt>
                <c:pt idx="42">
                  <c:v>X6279</c:v>
                </c:pt>
                <c:pt idx="43">
                  <c:v>X7031</c:v>
                </c:pt>
                <c:pt idx="44">
                  <c:v>X8187</c:v>
                </c:pt>
                <c:pt idx="45">
                  <c:v>X10551</c:v>
                </c:pt>
                <c:pt idx="46">
                  <c:v>X3512</c:v>
                </c:pt>
                <c:pt idx="47">
                  <c:v>X4680</c:v>
                </c:pt>
                <c:pt idx="48">
                  <c:v>X4830</c:v>
                </c:pt>
                <c:pt idx="49">
                  <c:v>X8644</c:v>
                </c:pt>
              </c:strCache>
            </c:strRef>
          </c:cat>
          <c:val>
            <c:numRef>
              <c:f>Sheet2!$C$2:$C$51</c:f>
              <c:numCache>
                <c:formatCode>General</c:formatCode>
                <c:ptCount val="50"/>
                <c:pt idx="0">
                  <c:v>63</c:v>
                </c:pt>
                <c:pt idx="1">
                  <c:v>54</c:v>
                </c:pt>
                <c:pt idx="2">
                  <c:v>49</c:v>
                </c:pt>
                <c:pt idx="3">
                  <c:v>46</c:v>
                </c:pt>
                <c:pt idx="4">
                  <c:v>37</c:v>
                </c:pt>
                <c:pt idx="5">
                  <c:v>30</c:v>
                </c:pt>
                <c:pt idx="6">
                  <c:v>30</c:v>
                </c:pt>
                <c:pt idx="7">
                  <c:v>26</c:v>
                </c:pt>
                <c:pt idx="8">
                  <c:v>26</c:v>
                </c:pt>
                <c:pt idx="9">
                  <c:v>25</c:v>
                </c:pt>
                <c:pt idx="10">
                  <c:v>23</c:v>
                </c:pt>
                <c:pt idx="11">
                  <c:v>22</c:v>
                </c:pt>
                <c:pt idx="12">
                  <c:v>21</c:v>
                </c:pt>
                <c:pt idx="13">
                  <c:v>19</c:v>
                </c:pt>
                <c:pt idx="14">
                  <c:v>19</c:v>
                </c:pt>
                <c:pt idx="15">
                  <c:v>19</c:v>
                </c:pt>
                <c:pt idx="16">
                  <c:v>19</c:v>
                </c:pt>
                <c:pt idx="17">
                  <c:v>18</c:v>
                </c:pt>
                <c:pt idx="18">
                  <c:v>17</c:v>
                </c:pt>
                <c:pt idx="19">
                  <c:v>17</c:v>
                </c:pt>
                <c:pt idx="20">
                  <c:v>17</c:v>
                </c:pt>
                <c:pt idx="21">
                  <c:v>16</c:v>
                </c:pt>
                <c:pt idx="22">
                  <c:v>15</c:v>
                </c:pt>
                <c:pt idx="23">
                  <c:v>15</c:v>
                </c:pt>
                <c:pt idx="24">
                  <c:v>14</c:v>
                </c:pt>
                <c:pt idx="25">
                  <c:v>14</c:v>
                </c:pt>
                <c:pt idx="26">
                  <c:v>13</c:v>
                </c:pt>
                <c:pt idx="27">
                  <c:v>13</c:v>
                </c:pt>
                <c:pt idx="28">
                  <c:v>13</c:v>
                </c:pt>
                <c:pt idx="29">
                  <c:v>13</c:v>
                </c:pt>
                <c:pt idx="30">
                  <c:v>13</c:v>
                </c:pt>
                <c:pt idx="31">
                  <c:v>13</c:v>
                </c:pt>
                <c:pt idx="32">
                  <c:v>12</c:v>
                </c:pt>
                <c:pt idx="33">
                  <c:v>12</c:v>
                </c:pt>
                <c:pt idx="34">
                  <c:v>12</c:v>
                </c:pt>
                <c:pt idx="35">
                  <c:v>11</c:v>
                </c:pt>
                <c:pt idx="36">
                  <c:v>11</c:v>
                </c:pt>
                <c:pt idx="37">
                  <c:v>11</c:v>
                </c:pt>
                <c:pt idx="38">
                  <c:v>11</c:v>
                </c:pt>
                <c:pt idx="39">
                  <c:v>11</c:v>
                </c:pt>
                <c:pt idx="40">
                  <c:v>10</c:v>
                </c:pt>
                <c:pt idx="41">
                  <c:v>10</c:v>
                </c:pt>
                <c:pt idx="42">
                  <c:v>10</c:v>
                </c:pt>
                <c:pt idx="43">
                  <c:v>10</c:v>
                </c:pt>
                <c:pt idx="44">
                  <c:v>10</c:v>
                </c:pt>
                <c:pt idx="45">
                  <c:v>9</c:v>
                </c:pt>
                <c:pt idx="46">
                  <c:v>9</c:v>
                </c:pt>
                <c:pt idx="47">
                  <c:v>9</c:v>
                </c:pt>
                <c:pt idx="48">
                  <c:v>9</c:v>
                </c:pt>
                <c:pt idx="49">
                  <c:v>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C3F-43FB-BB17-5FE85DEDBC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9437024"/>
        <c:axId val="189437584"/>
      </c:lineChart>
      <c:catAx>
        <c:axId val="189437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89437584"/>
        <c:crosses val="autoZero"/>
        <c:auto val="1"/>
        <c:lblAlgn val="ctr"/>
        <c:lblOffset val="100"/>
        <c:noMultiLvlLbl val="0"/>
      </c:catAx>
      <c:valAx>
        <c:axId val="189437584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89437024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b-LU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Luminal_CV3_betas!$O$4</c:f>
              <c:strCache>
                <c:ptCount val="1"/>
                <c:pt idx="0">
                  <c:v>LASSO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Luminal_CV3_betas!$N$5:$N$34</c:f>
              <c:strCache>
                <c:ptCount val="30"/>
                <c:pt idx="0">
                  <c:v>X25805</c:v>
                </c:pt>
                <c:pt idx="1">
                  <c:v>X7031</c:v>
                </c:pt>
                <c:pt idx="2">
                  <c:v>X346562</c:v>
                </c:pt>
                <c:pt idx="3">
                  <c:v>X54898</c:v>
                </c:pt>
                <c:pt idx="4">
                  <c:v>X767</c:v>
                </c:pt>
                <c:pt idx="5">
                  <c:v>X6696</c:v>
                </c:pt>
                <c:pt idx="6">
                  <c:v>X5918</c:v>
                </c:pt>
                <c:pt idx="7">
                  <c:v>X5304</c:v>
                </c:pt>
                <c:pt idx="8">
                  <c:v>X1545</c:v>
                </c:pt>
                <c:pt idx="9">
                  <c:v>X1356</c:v>
                </c:pt>
                <c:pt idx="10">
                  <c:v>X2888</c:v>
                </c:pt>
                <c:pt idx="11">
                  <c:v>X10202</c:v>
                </c:pt>
                <c:pt idx="12">
                  <c:v>X79071</c:v>
                </c:pt>
                <c:pt idx="13">
                  <c:v>X55008</c:v>
                </c:pt>
                <c:pt idx="14">
                  <c:v>X1733</c:v>
                </c:pt>
                <c:pt idx="15">
                  <c:v>X7941</c:v>
                </c:pt>
                <c:pt idx="16">
                  <c:v>X760</c:v>
                </c:pt>
                <c:pt idx="17">
                  <c:v>X429</c:v>
                </c:pt>
                <c:pt idx="18">
                  <c:v>X4477</c:v>
                </c:pt>
                <c:pt idx="19">
                  <c:v>X3043</c:v>
                </c:pt>
                <c:pt idx="20">
                  <c:v>X3117</c:v>
                </c:pt>
                <c:pt idx="21">
                  <c:v>X10103</c:v>
                </c:pt>
                <c:pt idx="22">
                  <c:v>X55859</c:v>
                </c:pt>
                <c:pt idx="23">
                  <c:v>X9547</c:v>
                </c:pt>
                <c:pt idx="24">
                  <c:v>X2674</c:v>
                </c:pt>
                <c:pt idx="25">
                  <c:v>X85453</c:v>
                </c:pt>
                <c:pt idx="26">
                  <c:v>X1893</c:v>
                </c:pt>
                <c:pt idx="27">
                  <c:v>X5046</c:v>
                </c:pt>
                <c:pt idx="28">
                  <c:v>X360</c:v>
                </c:pt>
                <c:pt idx="29">
                  <c:v>X7503</c:v>
                </c:pt>
              </c:strCache>
            </c:strRef>
          </c:cat>
          <c:val>
            <c:numRef>
              <c:f>Luminal_CV3_betas!$O$5:$O$34</c:f>
              <c:numCache>
                <c:formatCode>General</c:formatCode>
                <c:ptCount val="30"/>
                <c:pt idx="0">
                  <c:v>0.18241273636215899</c:v>
                </c:pt>
                <c:pt idx="1">
                  <c:v>0.17488560664203801</c:v>
                </c:pt>
                <c:pt idx="2">
                  <c:v>0.14293258122569799</c:v>
                </c:pt>
                <c:pt idx="3">
                  <c:v>0.155216686636199</c:v>
                </c:pt>
                <c:pt idx="4">
                  <c:v>0.112072182960234</c:v>
                </c:pt>
                <c:pt idx="5">
                  <c:v>6.5568251973196601E-2</c:v>
                </c:pt>
                <c:pt idx="6">
                  <c:v>3.9401685858663701E-2</c:v>
                </c:pt>
                <c:pt idx="7">
                  <c:v>4.7662411936493697E-2</c:v>
                </c:pt>
                <c:pt idx="8">
                  <c:v>6.1462484730502399E-2</c:v>
                </c:pt>
                <c:pt idx="9">
                  <c:v>1.15466112151075E-2</c:v>
                </c:pt>
                <c:pt idx="10">
                  <c:v>7.9704868803112997E-4</c:v>
                </c:pt>
                <c:pt idx="11">
                  <c:v>1.00215579104788E-2</c:v>
                </c:pt>
                <c:pt idx="12">
                  <c:v>4.4177415355927403E-2</c:v>
                </c:pt>
                <c:pt idx="13">
                  <c:v>1.9294596127639001E-2</c:v>
                </c:pt>
                <c:pt idx="14">
                  <c:v>1.25599229406096E-2</c:v>
                </c:pt>
                <c:pt idx="15">
                  <c:v>5.1367504865938501E-3</c:v>
                </c:pt>
                <c:pt idx="16">
                  <c:v>-6.5883000069374899E-4</c:v>
                </c:pt>
                <c:pt idx="17">
                  <c:v>-2.2209981318212401E-2</c:v>
                </c:pt>
                <c:pt idx="18">
                  <c:v>-4.2706065173547102E-2</c:v>
                </c:pt>
                <c:pt idx="19">
                  <c:v>-5.3461735097057497E-2</c:v>
                </c:pt>
                <c:pt idx="20">
                  <c:v>-5.5544218679233398E-2</c:v>
                </c:pt>
                <c:pt idx="21">
                  <c:v>-8.4480020772027306E-2</c:v>
                </c:pt>
                <c:pt idx="22">
                  <c:v>-9.1950759592685699E-2</c:v>
                </c:pt>
                <c:pt idx="23">
                  <c:v>-8.0982554088736905E-2</c:v>
                </c:pt>
                <c:pt idx="24">
                  <c:v>-9.19190929014118E-2</c:v>
                </c:pt>
                <c:pt idx="25">
                  <c:v>-0.11271746352758399</c:v>
                </c:pt>
                <c:pt idx="26">
                  <c:v>-0.18277790009341499</c:v>
                </c:pt>
                <c:pt idx="27">
                  <c:v>-0.206617100345796</c:v>
                </c:pt>
                <c:pt idx="28">
                  <c:v>-0.23779668522529501</c:v>
                </c:pt>
                <c:pt idx="29">
                  <c:v>-0.324956994390778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BB6-4A86-B80C-9B419F3CFC9E}"/>
            </c:ext>
          </c:extLst>
        </c:ser>
        <c:ser>
          <c:idx val="1"/>
          <c:order val="1"/>
          <c:tx>
            <c:strRef>
              <c:f>Luminal_CV3_betas!$P$4</c:f>
              <c:strCache>
                <c:ptCount val="1"/>
                <c:pt idx="0">
                  <c:v>MU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Luminal_CV3_betas!$N$5:$N$34</c:f>
              <c:strCache>
                <c:ptCount val="30"/>
                <c:pt idx="0">
                  <c:v>X25805</c:v>
                </c:pt>
                <c:pt idx="1">
                  <c:v>X7031</c:v>
                </c:pt>
                <c:pt idx="2">
                  <c:v>X346562</c:v>
                </c:pt>
                <c:pt idx="3">
                  <c:v>X54898</c:v>
                </c:pt>
                <c:pt idx="4">
                  <c:v>X767</c:v>
                </c:pt>
                <c:pt idx="5">
                  <c:v>X6696</c:v>
                </c:pt>
                <c:pt idx="6">
                  <c:v>X5918</c:v>
                </c:pt>
                <c:pt idx="7">
                  <c:v>X5304</c:v>
                </c:pt>
                <c:pt idx="8">
                  <c:v>X1545</c:v>
                </c:pt>
                <c:pt idx="9">
                  <c:v>X1356</c:v>
                </c:pt>
                <c:pt idx="10">
                  <c:v>X2888</c:v>
                </c:pt>
                <c:pt idx="11">
                  <c:v>X10202</c:v>
                </c:pt>
                <c:pt idx="12">
                  <c:v>X79071</c:v>
                </c:pt>
                <c:pt idx="13">
                  <c:v>X55008</c:v>
                </c:pt>
                <c:pt idx="14">
                  <c:v>X1733</c:v>
                </c:pt>
                <c:pt idx="15">
                  <c:v>X7941</c:v>
                </c:pt>
                <c:pt idx="16">
                  <c:v>X760</c:v>
                </c:pt>
                <c:pt idx="17">
                  <c:v>X429</c:v>
                </c:pt>
                <c:pt idx="18">
                  <c:v>X4477</c:v>
                </c:pt>
                <c:pt idx="19">
                  <c:v>X3043</c:v>
                </c:pt>
                <c:pt idx="20">
                  <c:v>X3117</c:v>
                </c:pt>
                <c:pt idx="21">
                  <c:v>X10103</c:v>
                </c:pt>
                <c:pt idx="22">
                  <c:v>X55859</c:v>
                </c:pt>
                <c:pt idx="23">
                  <c:v>X9547</c:v>
                </c:pt>
                <c:pt idx="24">
                  <c:v>X2674</c:v>
                </c:pt>
                <c:pt idx="25">
                  <c:v>X85453</c:v>
                </c:pt>
                <c:pt idx="26">
                  <c:v>X1893</c:v>
                </c:pt>
                <c:pt idx="27">
                  <c:v>X5046</c:v>
                </c:pt>
                <c:pt idx="28">
                  <c:v>X360</c:v>
                </c:pt>
                <c:pt idx="29">
                  <c:v>X7503</c:v>
                </c:pt>
              </c:strCache>
            </c:strRef>
          </c:cat>
          <c:val>
            <c:numRef>
              <c:f>Luminal_CV3_betas!$P$5:$P$34</c:f>
              <c:numCache>
                <c:formatCode>General</c:formatCode>
                <c:ptCount val="30"/>
                <c:pt idx="0">
                  <c:v>0.169326500192991</c:v>
                </c:pt>
                <c:pt idx="1">
                  <c:v>0.14539608379653901</c:v>
                </c:pt>
                <c:pt idx="2">
                  <c:v>0.13669590423007699</c:v>
                </c:pt>
                <c:pt idx="3">
                  <c:v>0.116868803411908</c:v>
                </c:pt>
                <c:pt idx="4">
                  <c:v>8.1211594595441305E-2</c:v>
                </c:pt>
                <c:pt idx="5">
                  <c:v>3.9341564859094201E-2</c:v>
                </c:pt>
                <c:pt idx="6">
                  <c:v>3.91474344893026E-2</c:v>
                </c:pt>
                <c:pt idx="7">
                  <c:v>3.63746385473794E-2</c:v>
                </c:pt>
                <c:pt idx="8">
                  <c:v>3.4179167035359198E-2</c:v>
                </c:pt>
                <c:pt idx="9">
                  <c:v>1.8217371711358999E-2</c:v>
                </c:pt>
                <c:pt idx="10">
                  <c:v>1.43552016767088E-2</c:v>
                </c:pt>
                <c:pt idx="11">
                  <c:v>1.1327607272446E-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-1.18411947949532E-2</c:v>
                </c:pt>
                <c:pt idx="18">
                  <c:v>-3.3112644195548997E-2</c:v>
                </c:pt>
                <c:pt idx="19">
                  <c:v>-4.6333298885370501E-2</c:v>
                </c:pt>
                <c:pt idx="20">
                  <c:v>-4.8671809212571797E-2</c:v>
                </c:pt>
                <c:pt idx="21">
                  <c:v>-5.7202660692861201E-2</c:v>
                </c:pt>
                <c:pt idx="22">
                  <c:v>-6.8448737420569603E-2</c:v>
                </c:pt>
                <c:pt idx="23">
                  <c:v>-6.8856564510443197E-2</c:v>
                </c:pt>
                <c:pt idx="24">
                  <c:v>-7.4573447097847495E-2</c:v>
                </c:pt>
                <c:pt idx="25">
                  <c:v>-8.2605643291779399E-2</c:v>
                </c:pt>
                <c:pt idx="26">
                  <c:v>-0.170821364282852</c:v>
                </c:pt>
                <c:pt idx="27">
                  <c:v>-0.172785330594734</c:v>
                </c:pt>
                <c:pt idx="28">
                  <c:v>-0.20949535783932099</c:v>
                </c:pt>
                <c:pt idx="29">
                  <c:v>-0.28778073997975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BB6-4A86-B80C-9B419F3CFC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9440384"/>
        <c:axId val="189440944"/>
      </c:barChart>
      <c:catAx>
        <c:axId val="189440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89440944"/>
        <c:crosses val="autoZero"/>
        <c:auto val="1"/>
        <c:lblAlgn val="ctr"/>
        <c:lblOffset val="100"/>
        <c:noMultiLvlLbl val="0"/>
      </c:catAx>
      <c:valAx>
        <c:axId val="189440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894403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lb-L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b-LU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lb-LU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LASSO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1!$A$2:$A$51</c:f>
              <c:strCache>
                <c:ptCount val="50"/>
                <c:pt idx="0">
                  <c:v>X7503</c:v>
                </c:pt>
                <c:pt idx="1">
                  <c:v>X360</c:v>
                </c:pt>
                <c:pt idx="2">
                  <c:v>X25805</c:v>
                </c:pt>
                <c:pt idx="3">
                  <c:v>X7031</c:v>
                </c:pt>
                <c:pt idx="4">
                  <c:v>X2674</c:v>
                </c:pt>
                <c:pt idx="5">
                  <c:v>X85453</c:v>
                </c:pt>
                <c:pt idx="6">
                  <c:v>X5304</c:v>
                </c:pt>
                <c:pt idx="7">
                  <c:v>X54898</c:v>
                </c:pt>
                <c:pt idx="8">
                  <c:v>X55859</c:v>
                </c:pt>
                <c:pt idx="9">
                  <c:v>X10202</c:v>
                </c:pt>
                <c:pt idx="10">
                  <c:v>X1893</c:v>
                </c:pt>
                <c:pt idx="11">
                  <c:v>X3117</c:v>
                </c:pt>
                <c:pt idx="12">
                  <c:v>X346562</c:v>
                </c:pt>
                <c:pt idx="13">
                  <c:v>X5046</c:v>
                </c:pt>
                <c:pt idx="14">
                  <c:v>X3043</c:v>
                </c:pt>
                <c:pt idx="15">
                  <c:v>X2888</c:v>
                </c:pt>
                <c:pt idx="16">
                  <c:v>X760</c:v>
                </c:pt>
                <c:pt idx="17">
                  <c:v>X9547</c:v>
                </c:pt>
                <c:pt idx="18">
                  <c:v>X1556</c:v>
                </c:pt>
                <c:pt idx="19">
                  <c:v>X11283</c:v>
                </c:pt>
                <c:pt idx="20">
                  <c:v>X4477</c:v>
                </c:pt>
                <c:pt idx="21">
                  <c:v>X10103</c:v>
                </c:pt>
                <c:pt idx="22">
                  <c:v>X4680</c:v>
                </c:pt>
                <c:pt idx="23">
                  <c:v>X1545</c:v>
                </c:pt>
                <c:pt idx="24">
                  <c:v>X3006</c:v>
                </c:pt>
                <c:pt idx="25">
                  <c:v>X4604</c:v>
                </c:pt>
                <c:pt idx="26">
                  <c:v>X6696</c:v>
                </c:pt>
                <c:pt idx="27">
                  <c:v>X9536</c:v>
                </c:pt>
                <c:pt idx="28">
                  <c:v>X6252</c:v>
                </c:pt>
                <c:pt idx="29">
                  <c:v>X79589</c:v>
                </c:pt>
                <c:pt idx="30">
                  <c:v>X4283</c:v>
                </c:pt>
                <c:pt idx="31">
                  <c:v>X1733</c:v>
                </c:pt>
                <c:pt idx="32">
                  <c:v>X374</c:v>
                </c:pt>
                <c:pt idx="33">
                  <c:v>X7021</c:v>
                </c:pt>
                <c:pt idx="34">
                  <c:v>X1047</c:v>
                </c:pt>
                <c:pt idx="35">
                  <c:v>X3119</c:v>
                </c:pt>
                <c:pt idx="36">
                  <c:v>X4887</c:v>
                </c:pt>
                <c:pt idx="37">
                  <c:v>X5918</c:v>
                </c:pt>
                <c:pt idx="38">
                  <c:v>X4246</c:v>
                </c:pt>
                <c:pt idx="39">
                  <c:v>X429</c:v>
                </c:pt>
                <c:pt idx="40">
                  <c:v>X1311</c:v>
                </c:pt>
                <c:pt idx="41">
                  <c:v>X247</c:v>
                </c:pt>
                <c:pt idx="42">
                  <c:v>X2167</c:v>
                </c:pt>
                <c:pt idx="43">
                  <c:v>X347902</c:v>
                </c:pt>
                <c:pt idx="44">
                  <c:v>X767</c:v>
                </c:pt>
                <c:pt idx="45">
                  <c:v>X4137</c:v>
                </c:pt>
                <c:pt idx="46">
                  <c:v>X4250</c:v>
                </c:pt>
                <c:pt idx="47">
                  <c:v>X55008</c:v>
                </c:pt>
                <c:pt idx="48">
                  <c:v>X7138</c:v>
                </c:pt>
                <c:pt idx="49">
                  <c:v>X79071</c:v>
                </c:pt>
              </c:strCache>
            </c:strRef>
          </c:cat>
          <c:val>
            <c:numRef>
              <c:f>Sheet1!$B$2:$B$51</c:f>
              <c:numCache>
                <c:formatCode>General</c:formatCode>
                <c:ptCount val="50"/>
                <c:pt idx="0">
                  <c:v>86</c:v>
                </c:pt>
                <c:pt idx="1">
                  <c:v>85</c:v>
                </c:pt>
                <c:pt idx="2">
                  <c:v>75</c:v>
                </c:pt>
                <c:pt idx="3">
                  <c:v>74</c:v>
                </c:pt>
                <c:pt idx="4">
                  <c:v>66</c:v>
                </c:pt>
                <c:pt idx="5">
                  <c:v>66</c:v>
                </c:pt>
                <c:pt idx="6">
                  <c:v>63</c:v>
                </c:pt>
                <c:pt idx="7">
                  <c:v>63</c:v>
                </c:pt>
                <c:pt idx="8">
                  <c:v>63</c:v>
                </c:pt>
                <c:pt idx="9">
                  <c:v>60</c:v>
                </c:pt>
                <c:pt idx="10">
                  <c:v>58</c:v>
                </c:pt>
                <c:pt idx="11">
                  <c:v>53</c:v>
                </c:pt>
                <c:pt idx="12">
                  <c:v>53</c:v>
                </c:pt>
                <c:pt idx="13">
                  <c:v>51</c:v>
                </c:pt>
                <c:pt idx="14">
                  <c:v>50</c:v>
                </c:pt>
                <c:pt idx="15">
                  <c:v>49</c:v>
                </c:pt>
                <c:pt idx="16">
                  <c:v>47</c:v>
                </c:pt>
                <c:pt idx="17">
                  <c:v>47</c:v>
                </c:pt>
                <c:pt idx="18">
                  <c:v>46</c:v>
                </c:pt>
                <c:pt idx="19">
                  <c:v>45</c:v>
                </c:pt>
                <c:pt idx="20">
                  <c:v>45</c:v>
                </c:pt>
                <c:pt idx="21">
                  <c:v>44</c:v>
                </c:pt>
                <c:pt idx="22">
                  <c:v>37</c:v>
                </c:pt>
                <c:pt idx="23">
                  <c:v>35</c:v>
                </c:pt>
                <c:pt idx="24">
                  <c:v>34</c:v>
                </c:pt>
                <c:pt idx="25">
                  <c:v>34</c:v>
                </c:pt>
                <c:pt idx="26">
                  <c:v>33</c:v>
                </c:pt>
                <c:pt idx="27">
                  <c:v>33</c:v>
                </c:pt>
                <c:pt idx="28">
                  <c:v>32</c:v>
                </c:pt>
                <c:pt idx="29">
                  <c:v>32</c:v>
                </c:pt>
                <c:pt idx="30">
                  <c:v>31</c:v>
                </c:pt>
                <c:pt idx="31">
                  <c:v>30</c:v>
                </c:pt>
                <c:pt idx="32">
                  <c:v>30</c:v>
                </c:pt>
                <c:pt idx="33">
                  <c:v>30</c:v>
                </c:pt>
                <c:pt idx="34">
                  <c:v>29</c:v>
                </c:pt>
                <c:pt idx="35">
                  <c:v>29</c:v>
                </c:pt>
                <c:pt idx="36">
                  <c:v>29</c:v>
                </c:pt>
                <c:pt idx="37">
                  <c:v>29</c:v>
                </c:pt>
                <c:pt idx="38">
                  <c:v>28</c:v>
                </c:pt>
                <c:pt idx="39">
                  <c:v>28</c:v>
                </c:pt>
                <c:pt idx="40">
                  <c:v>27</c:v>
                </c:pt>
                <c:pt idx="41">
                  <c:v>27</c:v>
                </c:pt>
                <c:pt idx="42">
                  <c:v>25</c:v>
                </c:pt>
                <c:pt idx="43">
                  <c:v>25</c:v>
                </c:pt>
                <c:pt idx="44">
                  <c:v>25</c:v>
                </c:pt>
                <c:pt idx="45">
                  <c:v>24</c:v>
                </c:pt>
                <c:pt idx="46">
                  <c:v>24</c:v>
                </c:pt>
                <c:pt idx="47">
                  <c:v>24</c:v>
                </c:pt>
                <c:pt idx="48">
                  <c:v>24</c:v>
                </c:pt>
                <c:pt idx="49">
                  <c:v>2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0B9-4D05-8A50-3C5D480D0A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0324672"/>
        <c:axId val="190325232"/>
      </c:lineChart>
      <c:catAx>
        <c:axId val="190324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0325232"/>
        <c:crosses val="autoZero"/>
        <c:auto val="1"/>
        <c:lblAlgn val="ctr"/>
        <c:lblOffset val="100"/>
        <c:noMultiLvlLbl val="0"/>
      </c:catAx>
      <c:valAx>
        <c:axId val="190325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0324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b-LU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lb-LU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C$1</c:f>
              <c:strCache>
                <c:ptCount val="1"/>
                <c:pt idx="0">
                  <c:v>MUB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2!$A$2:$A$51</c:f>
              <c:strCache>
                <c:ptCount val="50"/>
                <c:pt idx="0">
                  <c:v>X7503</c:v>
                </c:pt>
                <c:pt idx="1">
                  <c:v>X360</c:v>
                </c:pt>
                <c:pt idx="2">
                  <c:v>X346562</c:v>
                </c:pt>
                <c:pt idx="3">
                  <c:v>X54898</c:v>
                </c:pt>
                <c:pt idx="4">
                  <c:v>X25805</c:v>
                </c:pt>
                <c:pt idx="5">
                  <c:v>X7031</c:v>
                </c:pt>
                <c:pt idx="6">
                  <c:v>X85453</c:v>
                </c:pt>
                <c:pt idx="7">
                  <c:v>X2674</c:v>
                </c:pt>
                <c:pt idx="8">
                  <c:v>X1893</c:v>
                </c:pt>
                <c:pt idx="9">
                  <c:v>X10202</c:v>
                </c:pt>
                <c:pt idx="10">
                  <c:v>X2888</c:v>
                </c:pt>
                <c:pt idx="11">
                  <c:v>X3043</c:v>
                </c:pt>
                <c:pt idx="12">
                  <c:v>X3117</c:v>
                </c:pt>
                <c:pt idx="13">
                  <c:v>X5046</c:v>
                </c:pt>
                <c:pt idx="14">
                  <c:v>X5304</c:v>
                </c:pt>
                <c:pt idx="15">
                  <c:v>X4887</c:v>
                </c:pt>
                <c:pt idx="16">
                  <c:v>X10103</c:v>
                </c:pt>
                <c:pt idx="17">
                  <c:v>X11283</c:v>
                </c:pt>
                <c:pt idx="18">
                  <c:v>X1311</c:v>
                </c:pt>
                <c:pt idx="19">
                  <c:v>X79589</c:v>
                </c:pt>
                <c:pt idx="20">
                  <c:v>X4604</c:v>
                </c:pt>
                <c:pt idx="21">
                  <c:v>X55008</c:v>
                </c:pt>
                <c:pt idx="22">
                  <c:v>X1545</c:v>
                </c:pt>
                <c:pt idx="23">
                  <c:v>X3006</c:v>
                </c:pt>
                <c:pt idx="24">
                  <c:v>X6696</c:v>
                </c:pt>
                <c:pt idx="25">
                  <c:v>X79071</c:v>
                </c:pt>
                <c:pt idx="26">
                  <c:v>X55859</c:v>
                </c:pt>
                <c:pt idx="27">
                  <c:v>X27250</c:v>
                </c:pt>
                <c:pt idx="28">
                  <c:v>X4680</c:v>
                </c:pt>
                <c:pt idx="29">
                  <c:v>X767</c:v>
                </c:pt>
                <c:pt idx="30">
                  <c:v>X9547</c:v>
                </c:pt>
                <c:pt idx="31">
                  <c:v>X9837</c:v>
                </c:pt>
                <c:pt idx="32">
                  <c:v>X1556</c:v>
                </c:pt>
                <c:pt idx="33">
                  <c:v>X3119</c:v>
                </c:pt>
                <c:pt idx="34">
                  <c:v>X374</c:v>
                </c:pt>
                <c:pt idx="35">
                  <c:v>X5918</c:v>
                </c:pt>
                <c:pt idx="36">
                  <c:v>X699</c:v>
                </c:pt>
                <c:pt idx="37">
                  <c:v>X7138</c:v>
                </c:pt>
                <c:pt idx="38">
                  <c:v>X1733</c:v>
                </c:pt>
                <c:pt idx="39">
                  <c:v>X2167</c:v>
                </c:pt>
                <c:pt idx="40">
                  <c:v>X4477</c:v>
                </c:pt>
                <c:pt idx="41">
                  <c:v>X7941</c:v>
                </c:pt>
                <c:pt idx="42">
                  <c:v>X10267</c:v>
                </c:pt>
                <c:pt idx="43">
                  <c:v>X1178</c:v>
                </c:pt>
                <c:pt idx="44">
                  <c:v>X3775</c:v>
                </c:pt>
                <c:pt idx="45">
                  <c:v>X4137</c:v>
                </c:pt>
                <c:pt idx="46">
                  <c:v>X4751</c:v>
                </c:pt>
                <c:pt idx="47">
                  <c:v>X7272</c:v>
                </c:pt>
                <c:pt idx="48">
                  <c:v>X760</c:v>
                </c:pt>
                <c:pt idx="49">
                  <c:v>X11212</c:v>
                </c:pt>
              </c:strCache>
            </c:strRef>
          </c:cat>
          <c:val>
            <c:numRef>
              <c:f>Sheet2!$C$2:$C$51</c:f>
              <c:numCache>
                <c:formatCode>General</c:formatCode>
                <c:ptCount val="50"/>
                <c:pt idx="0">
                  <c:v>59</c:v>
                </c:pt>
                <c:pt idx="1">
                  <c:v>41</c:v>
                </c:pt>
                <c:pt idx="2">
                  <c:v>30</c:v>
                </c:pt>
                <c:pt idx="3">
                  <c:v>30</c:v>
                </c:pt>
                <c:pt idx="4">
                  <c:v>27</c:v>
                </c:pt>
                <c:pt idx="5">
                  <c:v>26</c:v>
                </c:pt>
                <c:pt idx="6">
                  <c:v>26</c:v>
                </c:pt>
                <c:pt idx="7">
                  <c:v>25</c:v>
                </c:pt>
                <c:pt idx="8">
                  <c:v>19</c:v>
                </c:pt>
                <c:pt idx="9">
                  <c:v>18</c:v>
                </c:pt>
                <c:pt idx="10">
                  <c:v>16</c:v>
                </c:pt>
                <c:pt idx="11">
                  <c:v>16</c:v>
                </c:pt>
                <c:pt idx="12">
                  <c:v>16</c:v>
                </c:pt>
                <c:pt idx="13">
                  <c:v>15</c:v>
                </c:pt>
                <c:pt idx="14">
                  <c:v>15</c:v>
                </c:pt>
                <c:pt idx="15">
                  <c:v>14</c:v>
                </c:pt>
                <c:pt idx="16">
                  <c:v>12</c:v>
                </c:pt>
                <c:pt idx="17">
                  <c:v>11</c:v>
                </c:pt>
                <c:pt idx="18">
                  <c:v>11</c:v>
                </c:pt>
                <c:pt idx="19">
                  <c:v>11</c:v>
                </c:pt>
                <c:pt idx="20">
                  <c:v>10</c:v>
                </c:pt>
                <c:pt idx="21">
                  <c:v>10</c:v>
                </c:pt>
                <c:pt idx="22">
                  <c:v>9</c:v>
                </c:pt>
                <c:pt idx="23">
                  <c:v>9</c:v>
                </c:pt>
                <c:pt idx="24">
                  <c:v>9</c:v>
                </c:pt>
                <c:pt idx="25">
                  <c:v>9</c:v>
                </c:pt>
                <c:pt idx="26">
                  <c:v>8</c:v>
                </c:pt>
                <c:pt idx="27">
                  <c:v>7</c:v>
                </c:pt>
                <c:pt idx="28">
                  <c:v>7</c:v>
                </c:pt>
                <c:pt idx="29">
                  <c:v>7</c:v>
                </c:pt>
                <c:pt idx="30">
                  <c:v>7</c:v>
                </c:pt>
                <c:pt idx="31">
                  <c:v>7</c:v>
                </c:pt>
                <c:pt idx="32">
                  <c:v>6</c:v>
                </c:pt>
                <c:pt idx="33">
                  <c:v>6</c:v>
                </c:pt>
                <c:pt idx="34">
                  <c:v>6</c:v>
                </c:pt>
                <c:pt idx="35">
                  <c:v>6</c:v>
                </c:pt>
                <c:pt idx="36">
                  <c:v>6</c:v>
                </c:pt>
                <c:pt idx="37">
                  <c:v>6</c:v>
                </c:pt>
                <c:pt idx="38">
                  <c:v>5</c:v>
                </c:pt>
                <c:pt idx="39">
                  <c:v>5</c:v>
                </c:pt>
                <c:pt idx="40">
                  <c:v>5</c:v>
                </c:pt>
                <c:pt idx="41">
                  <c:v>5</c:v>
                </c:pt>
                <c:pt idx="42">
                  <c:v>4</c:v>
                </c:pt>
                <c:pt idx="43">
                  <c:v>4</c:v>
                </c:pt>
                <c:pt idx="44">
                  <c:v>4</c:v>
                </c:pt>
                <c:pt idx="45">
                  <c:v>4</c:v>
                </c:pt>
                <c:pt idx="46">
                  <c:v>4</c:v>
                </c:pt>
                <c:pt idx="47">
                  <c:v>4</c:v>
                </c:pt>
                <c:pt idx="48">
                  <c:v>4</c:v>
                </c:pt>
                <c:pt idx="49">
                  <c:v>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AB3-4836-B94F-636912D483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0327472"/>
        <c:axId val="190328032"/>
      </c:lineChart>
      <c:catAx>
        <c:axId val="190327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0328032"/>
        <c:crosses val="autoZero"/>
        <c:auto val="1"/>
        <c:lblAlgn val="ctr"/>
        <c:lblOffset val="100"/>
        <c:noMultiLvlLbl val="0"/>
      </c:catAx>
      <c:valAx>
        <c:axId val="190328032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03274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b-LU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N_CV3_betas!$U$7</c:f>
              <c:strCache>
                <c:ptCount val="1"/>
                <c:pt idx="0">
                  <c:v>LASSO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TN_CV3_betas!$T$8:$T$14</c:f>
              <c:strCache>
                <c:ptCount val="7"/>
                <c:pt idx="0">
                  <c:v>X3655</c:v>
                </c:pt>
                <c:pt idx="1">
                  <c:v>X27299</c:v>
                </c:pt>
                <c:pt idx="2">
                  <c:v>X2001</c:v>
                </c:pt>
                <c:pt idx="3">
                  <c:v>X6273</c:v>
                </c:pt>
                <c:pt idx="4">
                  <c:v>X10551</c:v>
                </c:pt>
                <c:pt idx="5">
                  <c:v>X6286</c:v>
                </c:pt>
                <c:pt idx="6">
                  <c:v>X1277</c:v>
                </c:pt>
              </c:strCache>
            </c:strRef>
          </c:cat>
          <c:val>
            <c:numRef>
              <c:f>TN_CV3_betas!$U$8:$U$14</c:f>
              <c:numCache>
                <c:formatCode>General</c:formatCode>
                <c:ptCount val="7"/>
                <c:pt idx="0">
                  <c:v>4.7036065174342202E-2</c:v>
                </c:pt>
                <c:pt idx="1">
                  <c:v>1.6531480163099199E-2</c:v>
                </c:pt>
                <c:pt idx="2">
                  <c:v>1.6526647051609299E-2</c:v>
                </c:pt>
                <c:pt idx="3">
                  <c:v>-1.35405683373249E-2</c:v>
                </c:pt>
                <c:pt idx="4">
                  <c:v>-3.16758040341426E-2</c:v>
                </c:pt>
                <c:pt idx="5">
                  <c:v>-5.7872408000335503E-2</c:v>
                </c:pt>
                <c:pt idx="6">
                  <c:v>-2.3092179289235799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C59-48E0-BD3B-FBB0553FE33A}"/>
            </c:ext>
          </c:extLst>
        </c:ser>
        <c:ser>
          <c:idx val="1"/>
          <c:order val="1"/>
          <c:tx>
            <c:strRef>
              <c:f>TN_CV3_betas!$V$7</c:f>
              <c:strCache>
                <c:ptCount val="1"/>
                <c:pt idx="0">
                  <c:v>MU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TN_CV3_betas!$T$8:$T$14</c:f>
              <c:strCache>
                <c:ptCount val="7"/>
                <c:pt idx="0">
                  <c:v>X3655</c:v>
                </c:pt>
                <c:pt idx="1">
                  <c:v>X27299</c:v>
                </c:pt>
                <c:pt idx="2">
                  <c:v>X2001</c:v>
                </c:pt>
                <c:pt idx="3">
                  <c:v>X6273</c:v>
                </c:pt>
                <c:pt idx="4">
                  <c:v>X10551</c:v>
                </c:pt>
                <c:pt idx="5">
                  <c:v>X6286</c:v>
                </c:pt>
                <c:pt idx="6">
                  <c:v>X1277</c:v>
                </c:pt>
              </c:strCache>
            </c:strRef>
          </c:cat>
          <c:val>
            <c:numRef>
              <c:f>TN_CV3_betas!$V$8:$V$14</c:f>
              <c:numCache>
                <c:formatCode>General</c:formatCode>
                <c:ptCount val="7"/>
                <c:pt idx="0">
                  <c:v>0.28332271275325299</c:v>
                </c:pt>
                <c:pt idx="1">
                  <c:v>0.22834474342539199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-0.188758113273436</c:v>
                </c:pt>
                <c:pt idx="6">
                  <c:v>-0.214276571352275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C59-48E0-BD3B-FBB0553FE3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0330832"/>
        <c:axId val="190690736"/>
      </c:barChart>
      <c:catAx>
        <c:axId val="190330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baseline="0">
                <a:solidFill>
                  <a:schemeClr val="tx1"/>
                </a:solidFill>
              </a:defRPr>
            </a:pPr>
            <a:endParaRPr lang="lb-LU"/>
          </a:p>
        </c:txPr>
        <c:crossAx val="190690736"/>
        <c:crosses val="autoZero"/>
        <c:auto val="1"/>
        <c:lblAlgn val="ctr"/>
        <c:lblOffset val="100"/>
        <c:noMultiLvlLbl val="0"/>
      </c:catAx>
      <c:valAx>
        <c:axId val="19069073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lb-LU"/>
          </a:p>
        </c:txPr>
        <c:crossAx val="190330832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baseline="0"/>
          </a:pPr>
          <a:endParaRPr lang="lb-L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/>
      </a:pPr>
      <a:endParaRPr lang="lb-LU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lb-LU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LASSO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1!$A$2:$A$51</c:f>
              <c:strCache>
                <c:ptCount val="50"/>
                <c:pt idx="0">
                  <c:v>X6286</c:v>
                </c:pt>
                <c:pt idx="1">
                  <c:v>X563</c:v>
                </c:pt>
                <c:pt idx="2">
                  <c:v>X5178</c:v>
                </c:pt>
                <c:pt idx="3">
                  <c:v>X6273</c:v>
                </c:pt>
                <c:pt idx="4">
                  <c:v>X27299</c:v>
                </c:pt>
                <c:pt idx="5">
                  <c:v>X8788</c:v>
                </c:pt>
                <c:pt idx="6">
                  <c:v>X10406</c:v>
                </c:pt>
                <c:pt idx="7">
                  <c:v>X1278</c:v>
                </c:pt>
                <c:pt idx="8">
                  <c:v>X1672</c:v>
                </c:pt>
                <c:pt idx="9">
                  <c:v>X10551</c:v>
                </c:pt>
                <c:pt idx="10">
                  <c:v>X79966</c:v>
                </c:pt>
                <c:pt idx="11">
                  <c:v>X5918</c:v>
                </c:pt>
                <c:pt idx="12">
                  <c:v>X3655</c:v>
                </c:pt>
                <c:pt idx="13">
                  <c:v>X4915</c:v>
                </c:pt>
                <c:pt idx="14">
                  <c:v>X6715</c:v>
                </c:pt>
                <c:pt idx="15">
                  <c:v>X81569</c:v>
                </c:pt>
                <c:pt idx="16">
                  <c:v>X2810</c:v>
                </c:pt>
                <c:pt idx="17">
                  <c:v>X1381</c:v>
                </c:pt>
                <c:pt idx="18">
                  <c:v>X51442</c:v>
                </c:pt>
                <c:pt idx="19">
                  <c:v>X3576</c:v>
                </c:pt>
                <c:pt idx="20">
                  <c:v>X27324</c:v>
                </c:pt>
                <c:pt idx="21">
                  <c:v>X1830</c:v>
                </c:pt>
                <c:pt idx="22">
                  <c:v>X26298</c:v>
                </c:pt>
                <c:pt idx="23">
                  <c:v>X5320</c:v>
                </c:pt>
                <c:pt idx="24">
                  <c:v>X634</c:v>
                </c:pt>
                <c:pt idx="25">
                  <c:v>X140597</c:v>
                </c:pt>
                <c:pt idx="26">
                  <c:v>X286527</c:v>
                </c:pt>
                <c:pt idx="27">
                  <c:v>X9052</c:v>
                </c:pt>
                <c:pt idx="28">
                  <c:v>X2052</c:v>
                </c:pt>
                <c:pt idx="29">
                  <c:v>X347</c:v>
                </c:pt>
                <c:pt idx="30">
                  <c:v>X55765</c:v>
                </c:pt>
                <c:pt idx="31">
                  <c:v>X6590</c:v>
                </c:pt>
                <c:pt idx="32">
                  <c:v>X2882</c:v>
                </c:pt>
                <c:pt idx="33">
                  <c:v>X7018</c:v>
                </c:pt>
                <c:pt idx="34">
                  <c:v>X1277</c:v>
                </c:pt>
                <c:pt idx="35">
                  <c:v>X22943</c:v>
                </c:pt>
                <c:pt idx="36">
                  <c:v>X6696</c:v>
                </c:pt>
                <c:pt idx="37">
                  <c:v>X7837</c:v>
                </c:pt>
                <c:pt idx="38">
                  <c:v>X79083</c:v>
                </c:pt>
                <c:pt idx="39">
                  <c:v>X4604</c:v>
                </c:pt>
                <c:pt idx="40">
                  <c:v>X827</c:v>
                </c:pt>
                <c:pt idx="41">
                  <c:v>X1029</c:v>
                </c:pt>
                <c:pt idx="42">
                  <c:v>X1728</c:v>
                </c:pt>
                <c:pt idx="43">
                  <c:v>X26577</c:v>
                </c:pt>
                <c:pt idx="44">
                  <c:v>X3117</c:v>
                </c:pt>
                <c:pt idx="45">
                  <c:v>X4435</c:v>
                </c:pt>
                <c:pt idx="46">
                  <c:v>X5806</c:v>
                </c:pt>
                <c:pt idx="47">
                  <c:v>X7503</c:v>
                </c:pt>
                <c:pt idx="48">
                  <c:v>X11013</c:v>
                </c:pt>
                <c:pt idx="49">
                  <c:v>X2173</c:v>
                </c:pt>
              </c:strCache>
            </c:strRef>
          </c:cat>
          <c:val>
            <c:numRef>
              <c:f>Sheet1!$B$2:$B$51</c:f>
              <c:numCache>
                <c:formatCode>General</c:formatCode>
                <c:ptCount val="50"/>
                <c:pt idx="0">
                  <c:v>78</c:v>
                </c:pt>
                <c:pt idx="1">
                  <c:v>76</c:v>
                </c:pt>
                <c:pt idx="2">
                  <c:v>74</c:v>
                </c:pt>
                <c:pt idx="3">
                  <c:v>74</c:v>
                </c:pt>
                <c:pt idx="4">
                  <c:v>69</c:v>
                </c:pt>
                <c:pt idx="5">
                  <c:v>63</c:v>
                </c:pt>
                <c:pt idx="6">
                  <c:v>58</c:v>
                </c:pt>
                <c:pt idx="7">
                  <c:v>57</c:v>
                </c:pt>
                <c:pt idx="8">
                  <c:v>55</c:v>
                </c:pt>
                <c:pt idx="9">
                  <c:v>53</c:v>
                </c:pt>
                <c:pt idx="10">
                  <c:v>53</c:v>
                </c:pt>
                <c:pt idx="11">
                  <c:v>49</c:v>
                </c:pt>
                <c:pt idx="12">
                  <c:v>48</c:v>
                </c:pt>
                <c:pt idx="13">
                  <c:v>47</c:v>
                </c:pt>
                <c:pt idx="14">
                  <c:v>46</c:v>
                </c:pt>
                <c:pt idx="15">
                  <c:v>45</c:v>
                </c:pt>
                <c:pt idx="16">
                  <c:v>41</c:v>
                </c:pt>
                <c:pt idx="17">
                  <c:v>40</c:v>
                </c:pt>
                <c:pt idx="18">
                  <c:v>40</c:v>
                </c:pt>
                <c:pt idx="19">
                  <c:v>38</c:v>
                </c:pt>
                <c:pt idx="20">
                  <c:v>36</c:v>
                </c:pt>
                <c:pt idx="21">
                  <c:v>33</c:v>
                </c:pt>
                <c:pt idx="22">
                  <c:v>32</c:v>
                </c:pt>
                <c:pt idx="23">
                  <c:v>32</c:v>
                </c:pt>
                <c:pt idx="24">
                  <c:v>32</c:v>
                </c:pt>
                <c:pt idx="25">
                  <c:v>31</c:v>
                </c:pt>
                <c:pt idx="26">
                  <c:v>30</c:v>
                </c:pt>
                <c:pt idx="27">
                  <c:v>30</c:v>
                </c:pt>
                <c:pt idx="28">
                  <c:v>29</c:v>
                </c:pt>
                <c:pt idx="29">
                  <c:v>29</c:v>
                </c:pt>
                <c:pt idx="30">
                  <c:v>29</c:v>
                </c:pt>
                <c:pt idx="31">
                  <c:v>29</c:v>
                </c:pt>
                <c:pt idx="32">
                  <c:v>28</c:v>
                </c:pt>
                <c:pt idx="33">
                  <c:v>27</c:v>
                </c:pt>
                <c:pt idx="34">
                  <c:v>26</c:v>
                </c:pt>
                <c:pt idx="35">
                  <c:v>25</c:v>
                </c:pt>
                <c:pt idx="36">
                  <c:v>25</c:v>
                </c:pt>
                <c:pt idx="37">
                  <c:v>25</c:v>
                </c:pt>
                <c:pt idx="38">
                  <c:v>25</c:v>
                </c:pt>
                <c:pt idx="39">
                  <c:v>24</c:v>
                </c:pt>
                <c:pt idx="40">
                  <c:v>24</c:v>
                </c:pt>
                <c:pt idx="41">
                  <c:v>23</c:v>
                </c:pt>
                <c:pt idx="42">
                  <c:v>23</c:v>
                </c:pt>
                <c:pt idx="43">
                  <c:v>23</c:v>
                </c:pt>
                <c:pt idx="44">
                  <c:v>23</c:v>
                </c:pt>
                <c:pt idx="45">
                  <c:v>23</c:v>
                </c:pt>
                <c:pt idx="46">
                  <c:v>23</c:v>
                </c:pt>
                <c:pt idx="47">
                  <c:v>23</c:v>
                </c:pt>
                <c:pt idx="48">
                  <c:v>22</c:v>
                </c:pt>
                <c:pt idx="49">
                  <c:v>2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074-4BDE-B70F-30A888C11D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0692976"/>
        <c:axId val="190693536"/>
      </c:lineChart>
      <c:catAx>
        <c:axId val="190692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0693536"/>
        <c:crosses val="autoZero"/>
        <c:auto val="1"/>
        <c:lblAlgn val="ctr"/>
        <c:lblOffset val="100"/>
        <c:noMultiLvlLbl val="0"/>
      </c:catAx>
      <c:valAx>
        <c:axId val="190693536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06929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b-LU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lb-LU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C$1</c:f>
              <c:strCache>
                <c:ptCount val="1"/>
                <c:pt idx="0">
                  <c:v>MUB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2!$A$2:$A$51</c:f>
              <c:strCache>
                <c:ptCount val="50"/>
                <c:pt idx="0">
                  <c:v>X6286</c:v>
                </c:pt>
                <c:pt idx="1">
                  <c:v>X27299</c:v>
                </c:pt>
                <c:pt idx="2">
                  <c:v>X563</c:v>
                </c:pt>
                <c:pt idx="3">
                  <c:v>X6273</c:v>
                </c:pt>
                <c:pt idx="4">
                  <c:v>X5178</c:v>
                </c:pt>
                <c:pt idx="5">
                  <c:v>X8788</c:v>
                </c:pt>
                <c:pt idx="6">
                  <c:v>X1278</c:v>
                </c:pt>
                <c:pt idx="7">
                  <c:v>X3655</c:v>
                </c:pt>
                <c:pt idx="8">
                  <c:v>X79966</c:v>
                </c:pt>
                <c:pt idx="9">
                  <c:v>X6715</c:v>
                </c:pt>
                <c:pt idx="10">
                  <c:v>X1672</c:v>
                </c:pt>
                <c:pt idx="11">
                  <c:v>X81569</c:v>
                </c:pt>
                <c:pt idx="12">
                  <c:v>X10406</c:v>
                </c:pt>
                <c:pt idx="13">
                  <c:v>X10551</c:v>
                </c:pt>
                <c:pt idx="14">
                  <c:v>X2810</c:v>
                </c:pt>
                <c:pt idx="15">
                  <c:v>X5918</c:v>
                </c:pt>
                <c:pt idx="16">
                  <c:v>X1381</c:v>
                </c:pt>
                <c:pt idx="17">
                  <c:v>X1830</c:v>
                </c:pt>
                <c:pt idx="18">
                  <c:v>X27324</c:v>
                </c:pt>
                <c:pt idx="19">
                  <c:v>X51442</c:v>
                </c:pt>
                <c:pt idx="20">
                  <c:v>X286527</c:v>
                </c:pt>
                <c:pt idx="21">
                  <c:v>X79083</c:v>
                </c:pt>
                <c:pt idx="22">
                  <c:v>X11013</c:v>
                </c:pt>
                <c:pt idx="23">
                  <c:v>X140597</c:v>
                </c:pt>
                <c:pt idx="24">
                  <c:v>X26298</c:v>
                </c:pt>
                <c:pt idx="25">
                  <c:v>X55765</c:v>
                </c:pt>
                <c:pt idx="26">
                  <c:v>X7018</c:v>
                </c:pt>
                <c:pt idx="27">
                  <c:v>X3576</c:v>
                </c:pt>
                <c:pt idx="28">
                  <c:v>X4915</c:v>
                </c:pt>
                <c:pt idx="29">
                  <c:v>X7162</c:v>
                </c:pt>
                <c:pt idx="30">
                  <c:v>X7837</c:v>
                </c:pt>
                <c:pt idx="31">
                  <c:v>X2052</c:v>
                </c:pt>
                <c:pt idx="32">
                  <c:v>X1029</c:v>
                </c:pt>
                <c:pt idx="33">
                  <c:v>X1728</c:v>
                </c:pt>
                <c:pt idx="34">
                  <c:v>X2167</c:v>
                </c:pt>
                <c:pt idx="35">
                  <c:v>X4781</c:v>
                </c:pt>
                <c:pt idx="36">
                  <c:v>X4891</c:v>
                </c:pt>
                <c:pt idx="37">
                  <c:v>X595</c:v>
                </c:pt>
                <c:pt idx="38">
                  <c:v>X634</c:v>
                </c:pt>
                <c:pt idx="39">
                  <c:v>X827</c:v>
                </c:pt>
                <c:pt idx="40">
                  <c:v>X9052</c:v>
                </c:pt>
                <c:pt idx="41">
                  <c:v>X9244</c:v>
                </c:pt>
                <c:pt idx="42">
                  <c:v>X1277</c:v>
                </c:pt>
                <c:pt idx="43">
                  <c:v>X1848</c:v>
                </c:pt>
                <c:pt idx="44">
                  <c:v>X2173</c:v>
                </c:pt>
                <c:pt idx="45">
                  <c:v>X347</c:v>
                </c:pt>
                <c:pt idx="46">
                  <c:v>X5806</c:v>
                </c:pt>
                <c:pt idx="47">
                  <c:v>X7503</c:v>
                </c:pt>
                <c:pt idx="48">
                  <c:v>X80162</c:v>
                </c:pt>
                <c:pt idx="49">
                  <c:v>X2564</c:v>
                </c:pt>
              </c:strCache>
            </c:strRef>
          </c:cat>
          <c:val>
            <c:numRef>
              <c:f>Sheet2!$C$2:$C$51</c:f>
              <c:numCache>
                <c:formatCode>General</c:formatCode>
                <c:ptCount val="50"/>
                <c:pt idx="0">
                  <c:v>51</c:v>
                </c:pt>
                <c:pt idx="1">
                  <c:v>44</c:v>
                </c:pt>
                <c:pt idx="2">
                  <c:v>44</c:v>
                </c:pt>
                <c:pt idx="3">
                  <c:v>40</c:v>
                </c:pt>
                <c:pt idx="4">
                  <c:v>36</c:v>
                </c:pt>
                <c:pt idx="5">
                  <c:v>31</c:v>
                </c:pt>
                <c:pt idx="6">
                  <c:v>29</c:v>
                </c:pt>
                <c:pt idx="7">
                  <c:v>29</c:v>
                </c:pt>
                <c:pt idx="8">
                  <c:v>26</c:v>
                </c:pt>
                <c:pt idx="9">
                  <c:v>24</c:v>
                </c:pt>
                <c:pt idx="10">
                  <c:v>21</c:v>
                </c:pt>
                <c:pt idx="11">
                  <c:v>21</c:v>
                </c:pt>
                <c:pt idx="12">
                  <c:v>19</c:v>
                </c:pt>
                <c:pt idx="13">
                  <c:v>19</c:v>
                </c:pt>
                <c:pt idx="14">
                  <c:v>19</c:v>
                </c:pt>
                <c:pt idx="15">
                  <c:v>18</c:v>
                </c:pt>
                <c:pt idx="16">
                  <c:v>17</c:v>
                </c:pt>
                <c:pt idx="17">
                  <c:v>13</c:v>
                </c:pt>
                <c:pt idx="18">
                  <c:v>13</c:v>
                </c:pt>
                <c:pt idx="19">
                  <c:v>13</c:v>
                </c:pt>
                <c:pt idx="20">
                  <c:v>12</c:v>
                </c:pt>
                <c:pt idx="21">
                  <c:v>12</c:v>
                </c:pt>
                <c:pt idx="22">
                  <c:v>11</c:v>
                </c:pt>
                <c:pt idx="23">
                  <c:v>11</c:v>
                </c:pt>
                <c:pt idx="24">
                  <c:v>11</c:v>
                </c:pt>
                <c:pt idx="25">
                  <c:v>11</c:v>
                </c:pt>
                <c:pt idx="26">
                  <c:v>11</c:v>
                </c:pt>
                <c:pt idx="27">
                  <c:v>10</c:v>
                </c:pt>
                <c:pt idx="28">
                  <c:v>10</c:v>
                </c:pt>
                <c:pt idx="29">
                  <c:v>10</c:v>
                </c:pt>
                <c:pt idx="30">
                  <c:v>10</c:v>
                </c:pt>
                <c:pt idx="31">
                  <c:v>9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8</c:v>
                </c:pt>
                <c:pt idx="37">
                  <c:v>8</c:v>
                </c:pt>
                <c:pt idx="38">
                  <c:v>8</c:v>
                </c:pt>
                <c:pt idx="39">
                  <c:v>8</c:v>
                </c:pt>
                <c:pt idx="40">
                  <c:v>8</c:v>
                </c:pt>
                <c:pt idx="41">
                  <c:v>8</c:v>
                </c:pt>
                <c:pt idx="42">
                  <c:v>7</c:v>
                </c:pt>
                <c:pt idx="43">
                  <c:v>7</c:v>
                </c:pt>
                <c:pt idx="44">
                  <c:v>7</c:v>
                </c:pt>
                <c:pt idx="45">
                  <c:v>7</c:v>
                </c:pt>
                <c:pt idx="46">
                  <c:v>7</c:v>
                </c:pt>
                <c:pt idx="47">
                  <c:v>7</c:v>
                </c:pt>
                <c:pt idx="48">
                  <c:v>7</c:v>
                </c:pt>
                <c:pt idx="49">
                  <c:v>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8E3-4666-A2EA-A276A66F04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0695776"/>
        <c:axId val="190696336"/>
      </c:lineChart>
      <c:catAx>
        <c:axId val="190695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0696336"/>
        <c:crosses val="autoZero"/>
        <c:auto val="1"/>
        <c:lblAlgn val="ctr"/>
        <c:lblOffset val="100"/>
        <c:noMultiLvlLbl val="0"/>
      </c:catAx>
      <c:valAx>
        <c:axId val="190696336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lb-LU"/>
          </a:p>
        </c:txPr>
        <c:crossAx val="1906957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b-LU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drawings/_rels/vmlDrawing1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drawings/_rels/vmlDrawing1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drawings/_rels/vmlDrawing1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drawings/_rels/vmlDrawing17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emf"/></Relationships>
</file>

<file path=ppt/drawings/_rels/vmlDrawing18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19.vml.rels><?xml version="1.0" encoding="UTF-8" standalone="yes"?>
<Relationships xmlns="http://schemas.openxmlformats.org/package/2006/relationships"><Relationship Id="rId1" Type="http://schemas.openxmlformats.org/officeDocument/2006/relationships/image" Target="../media/image2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0.vml.rels><?xml version="1.0" encoding="UTF-8" standalone="yes"?>
<Relationships xmlns="http://schemas.openxmlformats.org/package/2006/relationships"><Relationship Id="rId1" Type="http://schemas.openxmlformats.org/officeDocument/2006/relationships/image" Target="../media/image24.emf"/></Relationships>
</file>

<file path=ppt/drawings/_rels/vmlDrawing2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emf"/></Relationships>
</file>

<file path=ppt/drawings/_rels/vmlDrawing2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6.emf"/></Relationships>
</file>

<file path=ppt/drawings/_rels/vmlDrawing2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7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787A83-EEAE-476B-A366-61B9995FFE19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20C519-3312-426F-86F8-8FFA32348F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86953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0C519-3312-426F-86F8-8FFA32348F8D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5887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1043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6879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5535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4941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7186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4681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411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89136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5429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895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4253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B10FED-7D21-4936-AA7A-6407C8B08136}" type="datetimeFigureOut">
              <a:rPr lang="ko-KR" altLang="en-US" smtClean="0"/>
              <a:t>2018-09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95DB0D-CDDC-490B-9AA6-96C818EA2B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3497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7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4" Type="http://schemas.openxmlformats.org/officeDocument/2006/relationships/image" Target="../media/image8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8.vml"/><Relationship Id="rId4" Type="http://schemas.openxmlformats.org/officeDocument/2006/relationships/image" Target="../media/image9.emf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9.vml"/><Relationship Id="rId4" Type="http://schemas.openxmlformats.org/officeDocument/2006/relationships/image" Target="../media/image11.em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0.vml"/><Relationship Id="rId4" Type="http://schemas.openxmlformats.org/officeDocument/2006/relationships/image" Target="../media/image12.em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1.vml"/><Relationship Id="rId4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2.vml"/><Relationship Id="rId4" Type="http://schemas.openxmlformats.org/officeDocument/2006/relationships/image" Target="../media/image14.em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3.vml"/><Relationship Id="rId4" Type="http://schemas.openxmlformats.org/officeDocument/2006/relationships/image" Target="../media/image15.emf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4.vml"/><Relationship Id="rId4" Type="http://schemas.openxmlformats.org/officeDocument/2006/relationships/image" Target="../media/image17.emf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5.vml"/><Relationship Id="rId4" Type="http://schemas.openxmlformats.org/officeDocument/2006/relationships/image" Target="../media/image18.emf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6.vml"/><Relationship Id="rId4" Type="http://schemas.openxmlformats.org/officeDocument/2006/relationships/image" Target="../media/image19.emf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7.vml"/><Relationship Id="rId4" Type="http://schemas.openxmlformats.org/officeDocument/2006/relationships/image" Target="../media/image20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8.vml"/><Relationship Id="rId4" Type="http://schemas.openxmlformats.org/officeDocument/2006/relationships/image" Target="../media/image21.emf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9.vml"/><Relationship Id="rId4" Type="http://schemas.openxmlformats.org/officeDocument/2006/relationships/image" Target="../media/image23.emf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0.vml"/><Relationship Id="rId4" Type="http://schemas.openxmlformats.org/officeDocument/2006/relationships/image" Target="../media/image24.emf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1.vml"/><Relationship Id="rId4" Type="http://schemas.openxmlformats.org/officeDocument/2006/relationships/image" Target="../media/image25.emf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2.vml"/><Relationship Id="rId4" Type="http://schemas.openxmlformats.org/officeDocument/2006/relationships/image" Target="../media/image26.emf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3.vml"/><Relationship Id="rId4" Type="http://schemas.openxmlformats.org/officeDocument/2006/relationships/image" Target="../media/image2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5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3"/>
          <p:cNvSpPr>
            <a:spLocks noGrp="1"/>
          </p:cNvSpPr>
          <p:nvPr>
            <p:ph type="title"/>
          </p:nvPr>
        </p:nvSpPr>
        <p:spPr>
          <a:xfrm>
            <a:off x="685800" y="4406900"/>
            <a:ext cx="7772400" cy="1362075"/>
          </a:xfrm>
        </p:spPr>
        <p:txBody>
          <a:bodyPr/>
          <a:lstStyle/>
          <a:p>
            <a:r>
              <a:rPr lang="en-GB" altLang="ko-KR" dirty="0" smtClean="0"/>
              <a:t>POOLED DATABASE</a:t>
            </a:r>
            <a:endParaRPr lang="ko-KR" altLang="en-US" dirty="0"/>
          </a:p>
        </p:txBody>
      </p:sp>
      <p:sp>
        <p:nvSpPr>
          <p:cNvPr id="5" name="텍스트 개체 틀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Section 1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41220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5856019"/>
              </p:ext>
            </p:extLst>
          </p:nvPr>
        </p:nvGraphicFramePr>
        <p:xfrm>
          <a:off x="1775656" y="632656"/>
          <a:ext cx="5592688" cy="5592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53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75656" y="632656"/>
                        <a:ext cx="5592688" cy="5592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251520" y="260648"/>
            <a:ext cx="882047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632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ootstrap internal valid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us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optimism calculated within each bootstrap training sample.</a:t>
            </a: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2. HER2 posi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1397157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5075480"/>
              </p:ext>
            </p:extLst>
          </p:nvPr>
        </p:nvGraphicFramePr>
        <p:xfrm>
          <a:off x="1883668" y="740668"/>
          <a:ext cx="5376664" cy="5376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77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83668" y="740668"/>
                        <a:ext cx="5376664" cy="53766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79512" y="260648"/>
            <a:ext cx="885698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632+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ootstrap internal valid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us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optimism calculated within each bootstrap training sample.</a:t>
            </a: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2. HER2 posi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8715381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개체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8019797"/>
              </p:ext>
            </p:extLst>
          </p:nvPr>
        </p:nvGraphicFramePr>
        <p:xfrm>
          <a:off x="1919672" y="776672"/>
          <a:ext cx="5304656" cy="5304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406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8" name="개체 7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19672" y="776672"/>
                        <a:ext cx="5304656" cy="5304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323528" y="260648"/>
            <a:ext cx="84249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uble loop cross-validation</a:t>
            </a: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2. HER2 posi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2496839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2427" y="1075779"/>
            <a:ext cx="7099147" cy="4706442"/>
          </a:xfrm>
          <a:prstGeom prst="rect">
            <a:avLst/>
          </a:prstGeom>
        </p:spPr>
      </p:pic>
      <p:sp>
        <p:nvSpPr>
          <p:cNvPr id="4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2. HER2 posi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188640"/>
            <a:ext cx="903649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difference between the number of covariates selected by the LASSO and the MUB over the 100 bootstrap training samples.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965224" y="1228110"/>
            <a:ext cx="208823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6" name="Rectangle 5"/>
          <p:cNvSpPr/>
          <p:nvPr/>
        </p:nvSpPr>
        <p:spPr>
          <a:xfrm>
            <a:off x="752946" y="1879460"/>
            <a:ext cx="529812" cy="31683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/>
          <p:cNvSpPr/>
          <p:nvPr/>
        </p:nvSpPr>
        <p:spPr>
          <a:xfrm rot="16200000">
            <a:off x="-588456" y="3198168"/>
            <a:ext cx="33230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difference between the number of </a:t>
            </a:r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covariates selected </a:t>
            </a:r>
            <a:r>
              <a:rPr lang="en-GB" sz="12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by the LASSO and the MUB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135154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2159646"/>
              </p:ext>
            </p:extLst>
          </p:nvPr>
        </p:nvGraphicFramePr>
        <p:xfrm>
          <a:off x="323528" y="2079000"/>
          <a:ext cx="405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8445069"/>
              </p:ext>
            </p:extLst>
          </p:nvPr>
        </p:nvGraphicFramePr>
        <p:xfrm>
          <a:off x="4932040" y="2079000"/>
          <a:ext cx="405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2. HER2 posi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8460432" y="2003972"/>
            <a:ext cx="655859" cy="27667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/>
          <p:cNvSpPr/>
          <p:nvPr/>
        </p:nvSpPr>
        <p:spPr>
          <a:xfrm>
            <a:off x="3858726" y="1966686"/>
            <a:ext cx="639270" cy="27667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Rectangle 1"/>
          <p:cNvSpPr/>
          <p:nvPr/>
        </p:nvSpPr>
        <p:spPr>
          <a:xfrm>
            <a:off x="179513" y="188640"/>
            <a:ext cx="860884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centag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ime each gene was selected during the bootstrap replications by each covariate selection method. Only the 15 most selected genes are represented.</a:t>
            </a:r>
          </a:p>
        </p:txBody>
      </p:sp>
      <p:sp>
        <p:nvSpPr>
          <p:cNvPr id="9" name="Rectangle 8"/>
          <p:cNvSpPr/>
          <p:nvPr/>
        </p:nvSpPr>
        <p:spPr>
          <a:xfrm rot="16200000">
            <a:off x="-630750" y="3344854"/>
            <a:ext cx="18154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Percentage of selection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  <p:sp>
        <p:nvSpPr>
          <p:cNvPr id="10" name="Rectangle 9"/>
          <p:cNvSpPr/>
          <p:nvPr/>
        </p:nvSpPr>
        <p:spPr>
          <a:xfrm rot="16200000">
            <a:off x="4051612" y="3344854"/>
            <a:ext cx="18154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Percentage of selection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616028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 smtClean="0"/>
              <a:t>Luminal dataset</a:t>
            </a:r>
            <a:endParaRPr lang="ko-KR" altLang="en-US" dirty="0"/>
          </a:p>
        </p:txBody>
      </p:sp>
      <p:sp>
        <p:nvSpPr>
          <p:cNvPr id="5" name="텍스트 개체 틀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Section 3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650023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3. Luminal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8660115"/>
              </p:ext>
            </p:extLst>
          </p:nvPr>
        </p:nvGraphicFramePr>
        <p:xfrm>
          <a:off x="395536" y="1268760"/>
          <a:ext cx="8507288" cy="51797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0" y="188640"/>
            <a:ext cx="910850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rgraph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resenting on the y-axis the regression coefficients of the covariates selected by at least one of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ovariate selection method in the pooled database. The genes on the x-axis are sorted by decreasing order of their LASSO regression coefficients and are labelled as anonymised in the database.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261890" y="3615542"/>
            <a:ext cx="1260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Beta coefficient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23757575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개체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1437797"/>
              </p:ext>
            </p:extLst>
          </p:nvPr>
        </p:nvGraphicFramePr>
        <p:xfrm>
          <a:off x="1991680" y="848680"/>
          <a:ext cx="5160640" cy="51606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02" name="Acrobat Document" r:id="rId3" imgW="4800361" imgH="4800441" progId="AcroExch.Document.DC">
                  <p:embed/>
                </p:oleObj>
              </mc:Choice>
              <mc:Fallback>
                <p:oleObj name="Acrobat Document" r:id="rId3" imgW="4800361" imgH="4800441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91680" y="848680"/>
                        <a:ext cx="5160640" cy="51606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/>
          <p:nvPr/>
        </p:nvSpPr>
        <p:spPr>
          <a:xfrm>
            <a:off x="179512" y="188640"/>
            <a:ext cx="896448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OC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urves of the linear predictors built with the selected covariates of each method. MUB: solid line; LASSO dotted line.</a:t>
            </a:r>
          </a:p>
        </p:txBody>
      </p:sp>
      <p:sp>
        <p:nvSpPr>
          <p:cNvPr id="5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3. Luminal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485177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3865898"/>
              </p:ext>
            </p:extLst>
          </p:nvPr>
        </p:nvGraphicFramePr>
        <p:xfrm>
          <a:off x="1883668" y="740668"/>
          <a:ext cx="5376664" cy="5376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4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83668" y="740668"/>
                        <a:ext cx="5376664" cy="53766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ko-KR" smtClean="0"/>
              <a:t>3. Luminal data</a:t>
            </a:r>
            <a:endParaRPr lang="ko-KR" altLang="en-US"/>
          </a:p>
        </p:txBody>
      </p:sp>
      <p:sp>
        <p:nvSpPr>
          <p:cNvPr id="6" name="Rectangle 5"/>
          <p:cNvSpPr/>
          <p:nvPr/>
        </p:nvSpPr>
        <p:spPr>
          <a:xfrm>
            <a:off x="323528" y="260648"/>
            <a:ext cx="84249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regular bootstrap internal validation technique using the optimism calculated within each bootstrap training sample.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1918892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4869440"/>
              </p:ext>
            </p:extLst>
          </p:nvPr>
        </p:nvGraphicFramePr>
        <p:xfrm>
          <a:off x="1712674" y="569674"/>
          <a:ext cx="5718652" cy="57186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50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12674" y="569674"/>
                        <a:ext cx="5718652" cy="57186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07504" y="260648"/>
            <a:ext cx="878497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632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ootstrap internal valid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us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optimism calculated within each bootstrap training sample.</a:t>
            </a: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3. Luminal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4167015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개체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0571582"/>
              </p:ext>
            </p:extLst>
          </p:nvPr>
        </p:nvGraphicFramePr>
        <p:xfrm>
          <a:off x="1955676" y="812676"/>
          <a:ext cx="5232648" cy="52326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57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7" name="개체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55676" y="812676"/>
                        <a:ext cx="5232648" cy="52326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1. Pooled database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23528" y="260648"/>
            <a:ext cx="882047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632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ootstrap internal valid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us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optimism calculated within each bootstrap training sample.</a:t>
            </a:r>
          </a:p>
        </p:txBody>
      </p:sp>
      <p:sp>
        <p:nvSpPr>
          <p:cNvPr id="5" name="TextBox 4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1261096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6918495"/>
              </p:ext>
            </p:extLst>
          </p:nvPr>
        </p:nvGraphicFramePr>
        <p:xfrm>
          <a:off x="1883668" y="740668"/>
          <a:ext cx="5376664" cy="5376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74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83668" y="740668"/>
                        <a:ext cx="5376664" cy="53766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79512" y="260648"/>
            <a:ext cx="882047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632+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ootstrap internal valid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us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optimism calculated within each bootstrap training sample.</a:t>
            </a: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3. Luminal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25790438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개체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3458407"/>
              </p:ext>
            </p:extLst>
          </p:nvPr>
        </p:nvGraphicFramePr>
        <p:xfrm>
          <a:off x="1883668" y="740668"/>
          <a:ext cx="5376664" cy="5376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503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8" name="개체 7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83668" y="740668"/>
                        <a:ext cx="5376664" cy="53766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323528" y="260648"/>
            <a:ext cx="84249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uble loop cross-validation</a:t>
            </a: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3. Luminal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26858581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0439" y="1147387"/>
            <a:ext cx="6883123" cy="4563227"/>
          </a:xfrm>
          <a:prstGeom prst="rect">
            <a:avLst/>
          </a:prstGeom>
        </p:spPr>
      </p:pic>
      <p:sp>
        <p:nvSpPr>
          <p:cNvPr id="4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3. Luminal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79512" y="188640"/>
            <a:ext cx="878497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difference between the number of covariates selected by the LASSO and the MUB over the 100 bootstrap training samples.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635896" y="1228110"/>
            <a:ext cx="208823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7" name="Rectangle 6"/>
          <p:cNvSpPr/>
          <p:nvPr/>
        </p:nvSpPr>
        <p:spPr>
          <a:xfrm>
            <a:off x="802649" y="1865606"/>
            <a:ext cx="529812" cy="31683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/>
          <p:cNvSpPr/>
          <p:nvPr/>
        </p:nvSpPr>
        <p:spPr>
          <a:xfrm rot="16200000">
            <a:off x="-478174" y="3198168"/>
            <a:ext cx="33230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difference between the number of </a:t>
            </a:r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covariates selected </a:t>
            </a:r>
            <a:r>
              <a:rPr lang="en-GB" sz="12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by the LASSO and the MUB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0825197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5387136"/>
              </p:ext>
            </p:extLst>
          </p:nvPr>
        </p:nvGraphicFramePr>
        <p:xfrm>
          <a:off x="395536" y="2069924"/>
          <a:ext cx="405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1800825"/>
              </p:ext>
            </p:extLst>
          </p:nvPr>
        </p:nvGraphicFramePr>
        <p:xfrm>
          <a:off x="5076056" y="2069924"/>
          <a:ext cx="405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3. Luminal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951638" y="2235307"/>
            <a:ext cx="792088" cy="25922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/>
          <p:cNvSpPr/>
          <p:nvPr/>
        </p:nvSpPr>
        <p:spPr>
          <a:xfrm>
            <a:off x="8621037" y="2003972"/>
            <a:ext cx="495254" cy="27667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/>
          <p:cNvSpPr/>
          <p:nvPr/>
        </p:nvSpPr>
        <p:spPr>
          <a:xfrm>
            <a:off x="0" y="188640"/>
            <a:ext cx="91440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centag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ime each gene was selected during the bootstrap replications by each covariate selection method. Only the 15 most selected genes are represented.</a:t>
            </a:r>
          </a:p>
        </p:txBody>
      </p:sp>
      <p:sp>
        <p:nvSpPr>
          <p:cNvPr id="9" name="Rectangle 8"/>
          <p:cNvSpPr/>
          <p:nvPr/>
        </p:nvSpPr>
        <p:spPr>
          <a:xfrm rot="16200000">
            <a:off x="-625924" y="3292389"/>
            <a:ext cx="18154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Percentage of selection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  <p:sp>
        <p:nvSpPr>
          <p:cNvPr id="10" name="Rectangle 9"/>
          <p:cNvSpPr/>
          <p:nvPr/>
        </p:nvSpPr>
        <p:spPr>
          <a:xfrm rot="16200000">
            <a:off x="4051612" y="3344854"/>
            <a:ext cx="18154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Percentage of selection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3892436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 smtClean="0"/>
              <a:t>Triple negative dataset</a:t>
            </a:r>
            <a:endParaRPr lang="ko-KR" altLang="en-US" dirty="0"/>
          </a:p>
        </p:txBody>
      </p:sp>
      <p:sp>
        <p:nvSpPr>
          <p:cNvPr id="5" name="텍스트 개체 틀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Section 4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840952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4. Triple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4482595"/>
              </p:ext>
            </p:extLst>
          </p:nvPr>
        </p:nvGraphicFramePr>
        <p:xfrm>
          <a:off x="457200" y="1417638"/>
          <a:ext cx="8229600" cy="4938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Rectangle 3"/>
          <p:cNvSpPr/>
          <p:nvPr/>
        </p:nvSpPr>
        <p:spPr>
          <a:xfrm>
            <a:off x="0" y="188640"/>
            <a:ext cx="910850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rgraph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resenting on the y-axis the regression coefficients of the covariates selected by at least one of the covariate selection method in the pooled database. The genes on the x-axis are sorted by decreasing order of their LASSO regression coefficients and are labelled as anonymised in the database.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261890" y="3615542"/>
            <a:ext cx="1260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Beta coefficient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40403004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개체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8034385"/>
              </p:ext>
            </p:extLst>
          </p:nvPr>
        </p:nvGraphicFramePr>
        <p:xfrm>
          <a:off x="2027684" y="884684"/>
          <a:ext cx="5088632" cy="50886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47" name="Acrobat Document" r:id="rId3" imgW="4800361" imgH="4800441" progId="AcroExch.Document.DC">
                  <p:embed/>
                </p:oleObj>
              </mc:Choice>
              <mc:Fallback>
                <p:oleObj name="Acrobat Document" r:id="rId3" imgW="4800361" imgH="4800441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27684" y="884684"/>
                        <a:ext cx="5088632" cy="50886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/>
          <p:nvPr/>
        </p:nvSpPr>
        <p:spPr>
          <a:xfrm>
            <a:off x="0" y="188640"/>
            <a:ext cx="903649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OC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urves of the linear predictors built with the selected covariates of each method. MUB: solid line; LASSO dotted line.</a:t>
            </a:r>
          </a:p>
        </p:txBody>
      </p:sp>
      <p:sp>
        <p:nvSpPr>
          <p:cNvPr id="5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4. Triple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063356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1483291"/>
              </p:ext>
            </p:extLst>
          </p:nvPr>
        </p:nvGraphicFramePr>
        <p:xfrm>
          <a:off x="1775656" y="632656"/>
          <a:ext cx="5592688" cy="5592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620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75656" y="632656"/>
                        <a:ext cx="5592688" cy="5592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323528" y="260648"/>
            <a:ext cx="84249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regular bootstrap internal validation technique using the optimism calculated within each bootstrap training sample.</a:t>
            </a: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4. Triple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2628139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8388077"/>
              </p:ext>
            </p:extLst>
          </p:nvPr>
        </p:nvGraphicFramePr>
        <p:xfrm>
          <a:off x="1769672" y="626672"/>
          <a:ext cx="5604656" cy="5604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45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69672" y="626672"/>
                        <a:ext cx="5604656" cy="5604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323528" y="260648"/>
            <a:ext cx="871296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632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ootstrap internal valid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us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optimism calculated within each bootstrap training sample.</a:t>
            </a: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4. Triple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21456835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8296522"/>
              </p:ext>
            </p:extLst>
          </p:nvPr>
        </p:nvGraphicFramePr>
        <p:xfrm>
          <a:off x="1595636" y="452636"/>
          <a:ext cx="5952728" cy="59527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69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95636" y="452636"/>
                        <a:ext cx="5952728" cy="59527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07504" y="260648"/>
            <a:ext cx="892899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632+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ootstrap internal valid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us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optimism calculated within each bootstrap training sample.</a:t>
            </a: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4. Triple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12481036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개체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8258898"/>
              </p:ext>
            </p:extLst>
          </p:nvPr>
        </p:nvGraphicFramePr>
        <p:xfrm>
          <a:off x="2171700" y="1028700"/>
          <a:ext cx="4800600" cy="4800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81" name="Acrobat Document" r:id="rId4" imgW="4800512" imgH="4800483" progId="AcroExch.Document.DC">
                  <p:embed/>
                </p:oleObj>
              </mc:Choice>
              <mc:Fallback>
                <p:oleObj name="Acrobat Document" r:id="rId4" imgW="4800512" imgH="4800483" progId="AcroExch.Document.DC">
                  <p:embed/>
                  <p:pic>
                    <p:nvPicPr>
                      <p:cNvPr id="7" name="개체 6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71700" y="1028700"/>
                        <a:ext cx="4800600" cy="4800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323528" y="260648"/>
            <a:ext cx="882047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632+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ootstrap internal valid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us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optimism calculated within each bootstrap training sample.</a:t>
            </a:r>
          </a:p>
        </p:txBody>
      </p:sp>
      <p:sp>
        <p:nvSpPr>
          <p:cNvPr id="6" name="바닥글 개체 틀 3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1. Pooled database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3852216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개체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4686103"/>
              </p:ext>
            </p:extLst>
          </p:nvPr>
        </p:nvGraphicFramePr>
        <p:xfrm>
          <a:off x="1775656" y="632656"/>
          <a:ext cx="5592688" cy="5592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597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8" name="개체 7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75656" y="632656"/>
                        <a:ext cx="5592688" cy="5592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323528" y="260648"/>
            <a:ext cx="84249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uble loop cross-validation</a:t>
            </a: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4. Triple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8740734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7669" y="1052736"/>
            <a:ext cx="7168662" cy="4752528"/>
          </a:xfrm>
          <a:prstGeom prst="rect">
            <a:avLst/>
          </a:prstGeom>
        </p:spPr>
      </p:pic>
      <p:sp>
        <p:nvSpPr>
          <p:cNvPr id="4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4. Triple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79512" y="188640"/>
            <a:ext cx="878497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difference between the number of covariates selected by the LASSO and the MUB over the 100 bootstrap training samples.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635896" y="1228110"/>
            <a:ext cx="208823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7" name="Rectangle 6"/>
          <p:cNvSpPr/>
          <p:nvPr/>
        </p:nvSpPr>
        <p:spPr>
          <a:xfrm>
            <a:off x="722763" y="1860135"/>
            <a:ext cx="529812" cy="31683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/>
          <p:cNvSpPr/>
          <p:nvPr/>
        </p:nvSpPr>
        <p:spPr>
          <a:xfrm rot="16200000">
            <a:off x="-597920" y="3198168"/>
            <a:ext cx="33230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difference between the number of </a:t>
            </a:r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covariates selected </a:t>
            </a:r>
            <a:r>
              <a:rPr lang="en-GB" sz="12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by the LASSO and the MUB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7871431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3317586"/>
              </p:ext>
            </p:extLst>
          </p:nvPr>
        </p:nvGraphicFramePr>
        <p:xfrm>
          <a:off x="395536" y="2079000"/>
          <a:ext cx="405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2581272"/>
              </p:ext>
            </p:extLst>
          </p:nvPr>
        </p:nvGraphicFramePr>
        <p:xfrm>
          <a:off x="5004048" y="2079000"/>
          <a:ext cx="405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4. Triple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879630" y="2276872"/>
            <a:ext cx="792088" cy="25922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/>
          <p:cNvSpPr/>
          <p:nvPr/>
        </p:nvSpPr>
        <p:spPr>
          <a:xfrm>
            <a:off x="8532440" y="2492896"/>
            <a:ext cx="611560" cy="25922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/>
          <p:cNvSpPr/>
          <p:nvPr/>
        </p:nvSpPr>
        <p:spPr>
          <a:xfrm>
            <a:off x="179513" y="188640"/>
            <a:ext cx="860884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centag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ime each gene was selected during the bootstrap replications by each covariate selection method. Only the 15 most selected genes are represented.</a:t>
            </a:r>
          </a:p>
        </p:txBody>
      </p:sp>
      <p:sp>
        <p:nvSpPr>
          <p:cNvPr id="9" name="Rectangle 8"/>
          <p:cNvSpPr/>
          <p:nvPr/>
        </p:nvSpPr>
        <p:spPr>
          <a:xfrm rot="16200000">
            <a:off x="-587206" y="3344854"/>
            <a:ext cx="18154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Percentage of selection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  <p:sp>
        <p:nvSpPr>
          <p:cNvPr id="10" name="Rectangle 9"/>
          <p:cNvSpPr/>
          <p:nvPr/>
        </p:nvSpPr>
        <p:spPr>
          <a:xfrm rot="16200000">
            <a:off x="4051612" y="3344854"/>
            <a:ext cx="18154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Percentage of selection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402051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 smtClean="0"/>
              <a:t>HER2 positive, ER negative dataset</a:t>
            </a:r>
            <a:endParaRPr lang="ko-KR" altLang="en-US" dirty="0"/>
          </a:p>
        </p:txBody>
      </p:sp>
      <p:sp>
        <p:nvSpPr>
          <p:cNvPr id="5" name="텍스트 개체 틀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Section 5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1653385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3103984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5. HER2 positive, ER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207407"/>
              </p:ext>
            </p:extLst>
          </p:nvPr>
        </p:nvGraphicFramePr>
        <p:xfrm>
          <a:off x="457200" y="1417638"/>
          <a:ext cx="8229600" cy="4938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Rectangle 3"/>
          <p:cNvSpPr/>
          <p:nvPr/>
        </p:nvSpPr>
        <p:spPr>
          <a:xfrm>
            <a:off x="0" y="188640"/>
            <a:ext cx="910850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rgraph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resenting on the y-axis the regression coefficients of the covariates selected by at least one of the covariate selection method in the pooled database. The genes on the x-axis are sorted by decreasing order of their LASSO regression coefficients and are labelled as anonymised in the database.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261890" y="3615542"/>
            <a:ext cx="1260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Beta coefficient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14448047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개체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6871685"/>
              </p:ext>
            </p:extLst>
          </p:nvPr>
        </p:nvGraphicFramePr>
        <p:xfrm>
          <a:off x="1631640" y="488640"/>
          <a:ext cx="5880720" cy="58807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4" name="Acrobat Document" r:id="rId3" imgW="4800361" imgH="4800441" progId="AcroExch.Document.DC">
                  <p:embed/>
                </p:oleObj>
              </mc:Choice>
              <mc:Fallback>
                <p:oleObj name="Acrobat Document" r:id="rId3" imgW="4800361" imgH="4800441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31640" y="488640"/>
                        <a:ext cx="5880720" cy="58807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/>
          <p:nvPr/>
        </p:nvSpPr>
        <p:spPr>
          <a:xfrm>
            <a:off x="0" y="188640"/>
            <a:ext cx="903649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D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OC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urves of the linear predictors built with the selected covariates of each method. MUB: solid line; LASSO dotted line.</a:t>
            </a:r>
          </a:p>
        </p:txBody>
      </p:sp>
      <p:sp>
        <p:nvSpPr>
          <p:cNvPr id="5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3103984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5. HER2 positive, ER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514603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4188285"/>
              </p:ext>
            </p:extLst>
          </p:nvPr>
        </p:nvGraphicFramePr>
        <p:xfrm>
          <a:off x="1775656" y="632656"/>
          <a:ext cx="5592688" cy="5592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716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75656" y="632656"/>
                        <a:ext cx="5592688" cy="5592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323528" y="260648"/>
            <a:ext cx="84249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E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regular bootstrap internal validation technique using the optimism calculated within each bootstrap training sample.</a:t>
            </a: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3103984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5. HER2 positive, ER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1861286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1537447"/>
              </p:ext>
            </p:extLst>
          </p:nvPr>
        </p:nvGraphicFramePr>
        <p:xfrm>
          <a:off x="1847664" y="704664"/>
          <a:ext cx="5448672" cy="54486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41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47664" y="704664"/>
                        <a:ext cx="5448672" cy="54486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323528" y="260648"/>
            <a:ext cx="871296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F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632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ootstrap internal valid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us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optimism calculated within each bootstrap training sample.</a:t>
            </a: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3103984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5. HER2 positive, ER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35732043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1332815"/>
              </p:ext>
            </p:extLst>
          </p:nvPr>
        </p:nvGraphicFramePr>
        <p:xfrm>
          <a:off x="1631640" y="488640"/>
          <a:ext cx="5880720" cy="58807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5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31640" y="488640"/>
                        <a:ext cx="5880720" cy="58807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07504" y="260648"/>
            <a:ext cx="892899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G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632+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ootstrap internal valid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using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optimism calculated within each bootstrap training sample.</a:t>
            </a:r>
          </a:p>
        </p:txBody>
      </p:sp>
      <p:sp>
        <p:nvSpPr>
          <p:cNvPr id="7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3103984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5. HER2 positive, ER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3212576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개체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8164113"/>
              </p:ext>
            </p:extLst>
          </p:nvPr>
        </p:nvGraphicFramePr>
        <p:xfrm>
          <a:off x="1823678" y="680678"/>
          <a:ext cx="5496644" cy="54966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694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8" name="개체 7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23678" y="680678"/>
                        <a:ext cx="5496644" cy="54966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323528" y="260648"/>
            <a:ext cx="84249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H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uble loop cross-validation</a:t>
            </a: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3103984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5. HER2 positive, ER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1962032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개체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4872546"/>
              </p:ext>
            </p:extLst>
          </p:nvPr>
        </p:nvGraphicFramePr>
        <p:xfrm>
          <a:off x="1787674" y="644674"/>
          <a:ext cx="5568652" cy="55686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09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8" name="개체 7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87674" y="644674"/>
                        <a:ext cx="5568652" cy="55686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323528" y="260648"/>
            <a:ext cx="84249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uble loop cross-validation</a:t>
            </a: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바닥글 개체 틀 3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1. Pooled database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159243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26536708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0170" y="1140579"/>
            <a:ext cx="6903661" cy="4576843"/>
          </a:xfrm>
          <a:prstGeom prst="rect">
            <a:avLst/>
          </a:prstGeom>
        </p:spPr>
      </p:pic>
      <p:sp>
        <p:nvSpPr>
          <p:cNvPr id="3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3103984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5. HER2 positive, ER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95536" y="188640"/>
            <a:ext cx="874846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I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difference between the number of covariates selected by the LASSO and the MUB over the 100 bootstrap training samples.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635896" y="1228110"/>
            <a:ext cx="208823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6" name="Rectangle 5"/>
          <p:cNvSpPr/>
          <p:nvPr/>
        </p:nvSpPr>
        <p:spPr>
          <a:xfrm>
            <a:off x="832780" y="1876725"/>
            <a:ext cx="529812" cy="31683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/>
          <p:cNvSpPr/>
          <p:nvPr/>
        </p:nvSpPr>
        <p:spPr>
          <a:xfrm rot="16200000">
            <a:off x="-521718" y="3198168"/>
            <a:ext cx="33230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difference between the number of </a:t>
            </a:r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covariates selected </a:t>
            </a:r>
            <a:r>
              <a:rPr lang="en-GB" sz="12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by the LASSO and the MUB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9025197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0716587"/>
              </p:ext>
            </p:extLst>
          </p:nvPr>
        </p:nvGraphicFramePr>
        <p:xfrm>
          <a:off x="467544" y="2079000"/>
          <a:ext cx="405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2592824"/>
              </p:ext>
            </p:extLst>
          </p:nvPr>
        </p:nvGraphicFramePr>
        <p:xfrm>
          <a:off x="5049545" y="2079000"/>
          <a:ext cx="405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3103984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5. HER2 positive, ER nega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979348" y="2276872"/>
            <a:ext cx="792088" cy="25922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ectangle 5"/>
          <p:cNvSpPr/>
          <p:nvPr/>
        </p:nvSpPr>
        <p:spPr>
          <a:xfrm>
            <a:off x="8582299" y="1988840"/>
            <a:ext cx="561701" cy="28803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/>
          <p:cNvSpPr/>
          <p:nvPr/>
        </p:nvSpPr>
        <p:spPr>
          <a:xfrm>
            <a:off x="107505" y="188640"/>
            <a:ext cx="868085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J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centag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ime each gene was selected during the bootstrap replications by each covariate selection method. Only the 15 most selected genes are represented.</a:t>
            </a:r>
          </a:p>
        </p:txBody>
      </p:sp>
      <p:sp>
        <p:nvSpPr>
          <p:cNvPr id="8" name="Rectangle 7"/>
          <p:cNvSpPr/>
          <p:nvPr/>
        </p:nvSpPr>
        <p:spPr>
          <a:xfrm rot="16200000">
            <a:off x="-511004" y="3323082"/>
            <a:ext cx="18154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Percentage of selection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  <p:sp>
        <p:nvSpPr>
          <p:cNvPr id="10" name="Rectangle 9"/>
          <p:cNvSpPr/>
          <p:nvPr/>
        </p:nvSpPr>
        <p:spPr>
          <a:xfrm rot="16200000">
            <a:off x="4051612" y="3344854"/>
            <a:ext cx="18154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Percentage of selection</a:t>
            </a:r>
            <a:endParaRPr lang="lb-LU" sz="12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053537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676456" y="2592614"/>
            <a:ext cx="453689" cy="24482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/>
          <p:cNvSpPr/>
          <p:nvPr/>
        </p:nvSpPr>
        <p:spPr>
          <a:xfrm>
            <a:off x="4139952" y="2592614"/>
            <a:ext cx="669713" cy="24482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4338" name="Picture 2" descr="C:\Users\han\Desktop\MUB\all_aucp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9699" y="1476750"/>
            <a:ext cx="5270217" cy="46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 rot="16200000">
            <a:off x="1397950" y="343392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  <p:sp>
        <p:nvSpPr>
          <p:cNvPr id="9" name="Rectangle 8"/>
          <p:cNvSpPr/>
          <p:nvPr/>
        </p:nvSpPr>
        <p:spPr>
          <a:xfrm>
            <a:off x="323528" y="260648"/>
            <a:ext cx="84249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PR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orrected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uble loop cross-validation</a:t>
            </a: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바닥글 개체 틀 3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1. Pooled database</a:t>
            </a:r>
            <a:endParaRPr lang="ko-KR" altLang="en-US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018008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dirty="0" smtClean="0"/>
              <a:t>Her2 positive dataset</a:t>
            </a:r>
            <a:endParaRPr lang="ko-KR" altLang="en-US" dirty="0"/>
          </a:p>
        </p:txBody>
      </p:sp>
      <p:sp>
        <p:nvSpPr>
          <p:cNvPr id="5" name="텍스트 개체 틀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Section 2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55471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2. HER2 posi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2938479"/>
              </p:ext>
            </p:extLst>
          </p:nvPr>
        </p:nvGraphicFramePr>
        <p:xfrm>
          <a:off x="457200" y="1417638"/>
          <a:ext cx="8229600" cy="4938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Rectangle 3"/>
          <p:cNvSpPr/>
          <p:nvPr/>
        </p:nvSpPr>
        <p:spPr>
          <a:xfrm>
            <a:off x="35496" y="188640"/>
            <a:ext cx="907300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rgraph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resenting on the y-axis the regression coefficients of the covariates selected by at least one of the covariate selection method in the pooled database. The genes on the x-axis are sorted by decreasing order of their LASSO regression coefficients and are labelled as anonymised in the database.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261890" y="3615542"/>
            <a:ext cx="1260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Beta coefficient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3584824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개체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7007955"/>
              </p:ext>
            </p:extLst>
          </p:nvPr>
        </p:nvGraphicFramePr>
        <p:xfrm>
          <a:off x="1800627" y="657627"/>
          <a:ext cx="5542746" cy="55427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4" name="Acrobat Document" r:id="rId3" imgW="4800361" imgH="4800441" progId="AcroExch.Document.DC">
                  <p:embed/>
                </p:oleObj>
              </mc:Choice>
              <mc:Fallback>
                <p:oleObj name="Acrobat Document" r:id="rId3" imgW="4800361" imgH="4800441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00627" y="657627"/>
                        <a:ext cx="5542746" cy="55427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179512" y="188640"/>
            <a:ext cx="896448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OC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urves of the linear predictors built with the selected covariates of each method. MUB: solid line; LASSO dotted line.</a:t>
            </a:r>
          </a:p>
        </p:txBody>
      </p:sp>
      <p:sp>
        <p:nvSpPr>
          <p:cNvPr id="5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2. HER2 posi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255777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0013307"/>
              </p:ext>
            </p:extLst>
          </p:nvPr>
        </p:nvGraphicFramePr>
        <p:xfrm>
          <a:off x="1667644" y="524644"/>
          <a:ext cx="5808712" cy="5808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28" name="Acrobat Document" r:id="rId3" imgW="4800512" imgH="4800483" progId="AcroExch.Document.DC">
                  <p:embed/>
                </p:oleObj>
              </mc:Choice>
              <mc:Fallback>
                <p:oleObj name="Acrobat Document" r:id="rId3" imgW="4800512" imgH="4800483" progId="AcroExch.Document.DC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67644" y="524644"/>
                        <a:ext cx="5808712" cy="5808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323528" y="260648"/>
            <a:ext cx="84249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f the AUC corrected by the regular bootstrap internal validation technique using the optimism calculated within each bootstrap training sample.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ko-KR" b="1" dirty="0" smtClean="0">
                <a:solidFill>
                  <a:schemeClr val="tx1"/>
                </a:solidFill>
              </a:rPr>
              <a:t>2. HER2 positive dataset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1559774" y="3241440"/>
            <a:ext cx="488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b-LU" sz="1200" dirty="0" smtClean="0"/>
              <a:t>AUC</a:t>
            </a:r>
            <a:endParaRPr lang="lb-LU" sz="1200" dirty="0"/>
          </a:p>
        </p:txBody>
      </p:sp>
    </p:spTree>
    <p:extLst>
      <p:ext uri="{BB962C8B-B14F-4D97-AF65-F5344CB8AC3E}">
        <p14:creationId xmlns:p14="http://schemas.microsoft.com/office/powerpoint/2010/main" val="39122814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24</TotalTime>
  <Words>1314</Words>
  <Application>Microsoft Office PowerPoint</Application>
  <PresentationFormat>On-screen Show (4:3)</PresentationFormat>
  <Paragraphs>133</Paragraphs>
  <Slides>4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1</vt:i4>
      </vt:variant>
    </vt:vector>
  </HeadingPairs>
  <TitlesOfParts>
    <vt:vector size="46" baseType="lpstr">
      <vt:lpstr>Malgun Gothic</vt:lpstr>
      <vt:lpstr>Malgun Gothic</vt:lpstr>
      <vt:lpstr>Arial</vt:lpstr>
      <vt:lpstr>Office 테마</vt:lpstr>
      <vt:lpstr>Acrobat Document</vt:lpstr>
      <vt:lpstr>POOLED DATABASE</vt:lpstr>
      <vt:lpstr>PowerPoint Presentation</vt:lpstr>
      <vt:lpstr>PowerPoint Presentation</vt:lpstr>
      <vt:lpstr>PowerPoint Presentation</vt:lpstr>
      <vt:lpstr>PowerPoint Presentation</vt:lpstr>
      <vt:lpstr>Her2 positive datas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Luminal datas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riple negative datas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HER2 positive, ER negative datas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parison of the modified unbounded penalty and the LASSO to select predictors of breast cancer chemotherapy resistance</dc:title>
  <dc:creator>안형미</dc:creator>
  <cp:lastModifiedBy>Olivier Collignon</cp:lastModifiedBy>
  <cp:revision>278</cp:revision>
  <cp:lastPrinted>2015-11-10T01:43:42Z</cp:lastPrinted>
  <dcterms:created xsi:type="dcterms:W3CDTF">2015-02-22T06:11:35Z</dcterms:created>
  <dcterms:modified xsi:type="dcterms:W3CDTF">2018-09-20T16:26:40Z</dcterms:modified>
</cp:coreProperties>
</file>